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30" r:id="rId1"/>
    <p:sldMasterId id="2147486297" r:id="rId2"/>
  </p:sldMasterIdLst>
  <p:notesMasterIdLst>
    <p:notesMasterId r:id="rId4"/>
  </p:notesMasterIdLst>
  <p:handoutMasterIdLst>
    <p:handoutMasterId r:id="rId5"/>
  </p:handoutMasterIdLst>
  <p:sldIdLst>
    <p:sldId id="2338" r:id="rId3"/>
  </p:sldIdLst>
  <p:sldSz cx="9144000" cy="6858000" type="screen4x3"/>
  <p:notesSz cx="6797675" cy="9926638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9966"/>
    <a:srgbClr val="FF3300"/>
    <a:srgbClr val="6600FF"/>
    <a:srgbClr val="9933FF"/>
    <a:srgbClr val="FF33CC"/>
    <a:srgbClr val="FFFF00"/>
    <a:srgbClr val="000066"/>
    <a:srgbClr val="66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74" autoAdjust="0"/>
    <p:restoredTop sz="92627" autoAdjust="0"/>
  </p:normalViewPr>
  <p:slideViewPr>
    <p:cSldViewPr>
      <p:cViewPr varScale="1">
        <p:scale>
          <a:sx n="80" d="100"/>
          <a:sy n="80" d="100"/>
        </p:scale>
        <p:origin x="1478" y="4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200" b="0" i="0" u="none" strike="noStrike" kern="1200" cap="none" spc="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  <a:ea typeface="+mj-ea"/>
                <a:cs typeface="+mj-cs"/>
              </a:defRPr>
            </a:pPr>
            <a:r>
              <a:rPr lang="en-US" altLang="ja-JP" dirty="0"/>
              <a:t>Males</a:t>
            </a:r>
            <a:endParaRPr lang="ja-JP" dirty="0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lineChart>
        <c:grouping val="standard"/>
        <c:varyColors val="0"/>
        <c:ser>
          <c:idx val="1"/>
          <c:order val="0"/>
          <c:tx>
            <c:strRef>
              <c:f>Sheet1!$C$1</c:f>
              <c:strCache>
                <c:ptCount val="1"/>
                <c:pt idx="0">
                  <c:v>胃</c:v>
                </c:pt>
              </c:strCache>
            </c:strRef>
          </c:tx>
          <c:spPr>
            <a:ln w="3810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Sheet1!$A$2:$A$62</c:f>
              <c:numCache>
                <c:formatCode>General</c:formatCode>
                <c:ptCount val="61"/>
                <c:pt idx="0">
                  <c:v>1958</c:v>
                </c:pt>
                <c:pt idx="1">
                  <c:v>1959</c:v>
                </c:pt>
                <c:pt idx="2">
                  <c:v>1960</c:v>
                </c:pt>
                <c:pt idx="3">
                  <c:v>1961</c:v>
                </c:pt>
                <c:pt idx="4">
                  <c:v>1962</c:v>
                </c:pt>
                <c:pt idx="5">
                  <c:v>1963</c:v>
                </c:pt>
                <c:pt idx="6">
                  <c:v>1964</c:v>
                </c:pt>
                <c:pt idx="7">
                  <c:v>1965</c:v>
                </c:pt>
                <c:pt idx="8">
                  <c:v>1966</c:v>
                </c:pt>
                <c:pt idx="9">
                  <c:v>1967</c:v>
                </c:pt>
                <c:pt idx="10">
                  <c:v>1968</c:v>
                </c:pt>
                <c:pt idx="11">
                  <c:v>1969</c:v>
                </c:pt>
                <c:pt idx="12">
                  <c:v>1970</c:v>
                </c:pt>
                <c:pt idx="13">
                  <c:v>1971</c:v>
                </c:pt>
                <c:pt idx="14">
                  <c:v>1972</c:v>
                </c:pt>
                <c:pt idx="15">
                  <c:v>1973</c:v>
                </c:pt>
                <c:pt idx="16">
                  <c:v>1974</c:v>
                </c:pt>
                <c:pt idx="17">
                  <c:v>1975</c:v>
                </c:pt>
                <c:pt idx="18">
                  <c:v>1976</c:v>
                </c:pt>
                <c:pt idx="19">
                  <c:v>1977</c:v>
                </c:pt>
                <c:pt idx="20">
                  <c:v>1978</c:v>
                </c:pt>
                <c:pt idx="21">
                  <c:v>1979</c:v>
                </c:pt>
                <c:pt idx="22">
                  <c:v>1980</c:v>
                </c:pt>
                <c:pt idx="23">
                  <c:v>1981</c:v>
                </c:pt>
                <c:pt idx="24">
                  <c:v>1982</c:v>
                </c:pt>
                <c:pt idx="25">
                  <c:v>1983</c:v>
                </c:pt>
                <c:pt idx="26">
                  <c:v>1984</c:v>
                </c:pt>
                <c:pt idx="27">
                  <c:v>1985</c:v>
                </c:pt>
                <c:pt idx="28">
                  <c:v>1986</c:v>
                </c:pt>
                <c:pt idx="29">
                  <c:v>1987</c:v>
                </c:pt>
                <c:pt idx="30">
                  <c:v>1988</c:v>
                </c:pt>
                <c:pt idx="31">
                  <c:v>1989</c:v>
                </c:pt>
                <c:pt idx="32">
                  <c:v>1990</c:v>
                </c:pt>
                <c:pt idx="33">
                  <c:v>1991</c:v>
                </c:pt>
                <c:pt idx="34">
                  <c:v>1992</c:v>
                </c:pt>
                <c:pt idx="35">
                  <c:v>1993</c:v>
                </c:pt>
                <c:pt idx="36">
                  <c:v>1994</c:v>
                </c:pt>
                <c:pt idx="37">
                  <c:v>1995</c:v>
                </c:pt>
                <c:pt idx="38">
                  <c:v>1996</c:v>
                </c:pt>
                <c:pt idx="39">
                  <c:v>1997</c:v>
                </c:pt>
                <c:pt idx="40">
                  <c:v>1998</c:v>
                </c:pt>
                <c:pt idx="41">
                  <c:v>1999</c:v>
                </c:pt>
                <c:pt idx="42">
                  <c:v>2000</c:v>
                </c:pt>
                <c:pt idx="43">
                  <c:v>2001</c:v>
                </c:pt>
                <c:pt idx="44">
                  <c:v>2002</c:v>
                </c:pt>
                <c:pt idx="45">
                  <c:v>2003</c:v>
                </c:pt>
                <c:pt idx="46">
                  <c:v>2004</c:v>
                </c:pt>
                <c:pt idx="47">
                  <c:v>2005</c:v>
                </c:pt>
                <c:pt idx="48">
                  <c:v>2006</c:v>
                </c:pt>
                <c:pt idx="49">
                  <c:v>2007</c:v>
                </c:pt>
                <c:pt idx="50">
                  <c:v>2008</c:v>
                </c:pt>
                <c:pt idx="51">
                  <c:v>2009</c:v>
                </c:pt>
                <c:pt idx="52">
                  <c:v>2010</c:v>
                </c:pt>
                <c:pt idx="53" formatCode="@">
                  <c:v>2011</c:v>
                </c:pt>
                <c:pt idx="54">
                  <c:v>2012</c:v>
                </c:pt>
                <c:pt idx="55">
                  <c:v>2013</c:v>
                </c:pt>
                <c:pt idx="56">
                  <c:v>2014</c:v>
                </c:pt>
                <c:pt idx="57">
                  <c:v>2015</c:v>
                </c:pt>
                <c:pt idx="58">
                  <c:v>2016</c:v>
                </c:pt>
                <c:pt idx="59">
                  <c:v>2017</c:v>
                </c:pt>
                <c:pt idx="60">
                  <c:v>2018</c:v>
                </c:pt>
              </c:numCache>
            </c:numRef>
          </c:cat>
          <c:val>
            <c:numRef>
              <c:f>Sheet1!$C$2:$C$62</c:f>
              <c:numCache>
                <c:formatCode>0.0_ </c:formatCode>
                <c:ptCount val="61"/>
                <c:pt idx="0">
                  <c:v>98.284128920000001</c:v>
                </c:pt>
                <c:pt idx="1">
                  <c:v>98.446460277</c:v>
                </c:pt>
                <c:pt idx="2">
                  <c:v>98.455402707999994</c:v>
                </c:pt>
                <c:pt idx="3">
                  <c:v>96.711493769</c:v>
                </c:pt>
                <c:pt idx="4">
                  <c:v>94.671133608999995</c:v>
                </c:pt>
                <c:pt idx="5">
                  <c:v>95.88210402</c:v>
                </c:pt>
                <c:pt idx="6">
                  <c:v>96.757334404000005</c:v>
                </c:pt>
                <c:pt idx="7">
                  <c:v>95.974496837000004</c:v>
                </c:pt>
                <c:pt idx="8">
                  <c:v>94.732672007999994</c:v>
                </c:pt>
                <c:pt idx="9">
                  <c:v>93.456324242999997</c:v>
                </c:pt>
                <c:pt idx="10">
                  <c:v>94.492751600999995</c:v>
                </c:pt>
                <c:pt idx="11">
                  <c:v>93.419691026999999</c:v>
                </c:pt>
                <c:pt idx="12">
                  <c:v>88.868613054999997</c:v>
                </c:pt>
                <c:pt idx="13">
                  <c:v>87.406242082999995</c:v>
                </c:pt>
                <c:pt idx="14">
                  <c:v>87.063785994</c:v>
                </c:pt>
                <c:pt idx="15">
                  <c:v>85.033779976000005</c:v>
                </c:pt>
                <c:pt idx="16">
                  <c:v>83.008797783000006</c:v>
                </c:pt>
                <c:pt idx="17">
                  <c:v>79.409296040000001</c:v>
                </c:pt>
                <c:pt idx="18">
                  <c:v>77.601147240000003</c:v>
                </c:pt>
                <c:pt idx="19">
                  <c:v>74.905462284999999</c:v>
                </c:pt>
                <c:pt idx="20">
                  <c:v>72.297258713000005</c:v>
                </c:pt>
                <c:pt idx="21">
                  <c:v>71.751485552999995</c:v>
                </c:pt>
                <c:pt idx="22">
                  <c:v>69.891346060000004</c:v>
                </c:pt>
                <c:pt idx="23">
                  <c:v>68.029238999</c:v>
                </c:pt>
                <c:pt idx="24">
                  <c:v>64.115962515999996</c:v>
                </c:pt>
                <c:pt idx="25">
                  <c:v>63.327879734</c:v>
                </c:pt>
                <c:pt idx="26">
                  <c:v>62.197382367000003</c:v>
                </c:pt>
                <c:pt idx="27">
                  <c:v>59.097094958</c:v>
                </c:pt>
                <c:pt idx="28">
                  <c:v>56.895429587000002</c:v>
                </c:pt>
                <c:pt idx="29">
                  <c:v>55.246809317</c:v>
                </c:pt>
                <c:pt idx="30">
                  <c:v>53.086393727000001</c:v>
                </c:pt>
                <c:pt idx="31">
                  <c:v>51.938548642999997</c:v>
                </c:pt>
                <c:pt idx="32">
                  <c:v>49.546740100000001</c:v>
                </c:pt>
                <c:pt idx="33">
                  <c:v>48.665143317999998</c:v>
                </c:pt>
                <c:pt idx="34">
                  <c:v>47.446070413000001</c:v>
                </c:pt>
                <c:pt idx="35">
                  <c:v>45.190747864000002</c:v>
                </c:pt>
                <c:pt idx="36">
                  <c:v>44.677490939999998</c:v>
                </c:pt>
                <c:pt idx="37">
                  <c:v>45.421633589000002</c:v>
                </c:pt>
                <c:pt idx="38">
                  <c:v>44.340897288999997</c:v>
                </c:pt>
                <c:pt idx="39">
                  <c:v>42.629831754999998</c:v>
                </c:pt>
                <c:pt idx="40">
                  <c:v>42.095850820000003</c:v>
                </c:pt>
                <c:pt idx="41">
                  <c:v>40.763031054999999</c:v>
                </c:pt>
                <c:pt idx="42">
                  <c:v>39.054335359</c:v>
                </c:pt>
                <c:pt idx="43">
                  <c:v>37.145430124000001</c:v>
                </c:pt>
                <c:pt idx="44">
                  <c:v>35.263648525000001</c:v>
                </c:pt>
                <c:pt idx="45">
                  <c:v>34.533739202</c:v>
                </c:pt>
                <c:pt idx="46">
                  <c:v>34.219890372999998</c:v>
                </c:pt>
                <c:pt idx="47">
                  <c:v>32.697755905000001</c:v>
                </c:pt>
                <c:pt idx="48">
                  <c:v>31.888452167000001</c:v>
                </c:pt>
                <c:pt idx="49">
                  <c:v>31.105349393000001</c:v>
                </c:pt>
                <c:pt idx="50">
                  <c:v>29.965760102000001</c:v>
                </c:pt>
                <c:pt idx="51">
                  <c:v>28.978419990999999</c:v>
                </c:pt>
                <c:pt idx="52">
                  <c:v>28.248339761</c:v>
                </c:pt>
                <c:pt idx="53" formatCode="0.0_);[Red]\(0.0\)">
                  <c:v>27.396932455086457</c:v>
                </c:pt>
                <c:pt idx="54" formatCode="0.0">
                  <c:v>26.127886079100517</c:v>
                </c:pt>
                <c:pt idx="55" formatCode="General">
                  <c:v>25.2</c:v>
                </c:pt>
                <c:pt idx="56" formatCode="General">
                  <c:v>24.1</c:v>
                </c:pt>
                <c:pt idx="57" formatCode="General">
                  <c:v>22.9</c:v>
                </c:pt>
                <c:pt idx="58" formatCode="General">
                  <c:v>21.6</c:v>
                </c:pt>
                <c:pt idx="59" formatCode="General">
                  <c:v>20.9</c:v>
                </c:pt>
                <c:pt idx="60" formatCode="0.0_);[Red]\(0.0\)">
                  <c:v>19.7425237403677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920-4B3F-9C94-DB0244CE5668}"/>
            </c:ext>
          </c:extLst>
        </c:ser>
        <c:ser>
          <c:idx val="2"/>
          <c:order val="1"/>
          <c:tx>
            <c:strRef>
              <c:f>Sheet1!$D$1</c:f>
              <c:strCache>
                <c:ptCount val="1"/>
                <c:pt idx="0">
                  <c:v>大腸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Sheet1!$A$2:$A$62</c:f>
              <c:numCache>
                <c:formatCode>General</c:formatCode>
                <c:ptCount val="61"/>
                <c:pt idx="0">
                  <c:v>1958</c:v>
                </c:pt>
                <c:pt idx="1">
                  <c:v>1959</c:v>
                </c:pt>
                <c:pt idx="2">
                  <c:v>1960</c:v>
                </c:pt>
                <c:pt idx="3">
                  <c:v>1961</c:v>
                </c:pt>
                <c:pt idx="4">
                  <c:v>1962</c:v>
                </c:pt>
                <c:pt idx="5">
                  <c:v>1963</c:v>
                </c:pt>
                <c:pt idx="6">
                  <c:v>1964</c:v>
                </c:pt>
                <c:pt idx="7">
                  <c:v>1965</c:v>
                </c:pt>
                <c:pt idx="8">
                  <c:v>1966</c:v>
                </c:pt>
                <c:pt idx="9">
                  <c:v>1967</c:v>
                </c:pt>
                <c:pt idx="10">
                  <c:v>1968</c:v>
                </c:pt>
                <c:pt idx="11">
                  <c:v>1969</c:v>
                </c:pt>
                <c:pt idx="12">
                  <c:v>1970</c:v>
                </c:pt>
                <c:pt idx="13">
                  <c:v>1971</c:v>
                </c:pt>
                <c:pt idx="14">
                  <c:v>1972</c:v>
                </c:pt>
                <c:pt idx="15">
                  <c:v>1973</c:v>
                </c:pt>
                <c:pt idx="16">
                  <c:v>1974</c:v>
                </c:pt>
                <c:pt idx="17">
                  <c:v>1975</c:v>
                </c:pt>
                <c:pt idx="18">
                  <c:v>1976</c:v>
                </c:pt>
                <c:pt idx="19">
                  <c:v>1977</c:v>
                </c:pt>
                <c:pt idx="20">
                  <c:v>1978</c:v>
                </c:pt>
                <c:pt idx="21">
                  <c:v>1979</c:v>
                </c:pt>
                <c:pt idx="22">
                  <c:v>1980</c:v>
                </c:pt>
                <c:pt idx="23">
                  <c:v>1981</c:v>
                </c:pt>
                <c:pt idx="24">
                  <c:v>1982</c:v>
                </c:pt>
                <c:pt idx="25">
                  <c:v>1983</c:v>
                </c:pt>
                <c:pt idx="26">
                  <c:v>1984</c:v>
                </c:pt>
                <c:pt idx="27">
                  <c:v>1985</c:v>
                </c:pt>
                <c:pt idx="28">
                  <c:v>1986</c:v>
                </c:pt>
                <c:pt idx="29">
                  <c:v>1987</c:v>
                </c:pt>
                <c:pt idx="30">
                  <c:v>1988</c:v>
                </c:pt>
                <c:pt idx="31">
                  <c:v>1989</c:v>
                </c:pt>
                <c:pt idx="32">
                  <c:v>1990</c:v>
                </c:pt>
                <c:pt idx="33">
                  <c:v>1991</c:v>
                </c:pt>
                <c:pt idx="34">
                  <c:v>1992</c:v>
                </c:pt>
                <c:pt idx="35">
                  <c:v>1993</c:v>
                </c:pt>
                <c:pt idx="36">
                  <c:v>1994</c:v>
                </c:pt>
                <c:pt idx="37">
                  <c:v>1995</c:v>
                </c:pt>
                <c:pt idx="38">
                  <c:v>1996</c:v>
                </c:pt>
                <c:pt idx="39">
                  <c:v>1997</c:v>
                </c:pt>
                <c:pt idx="40">
                  <c:v>1998</c:v>
                </c:pt>
                <c:pt idx="41">
                  <c:v>1999</c:v>
                </c:pt>
                <c:pt idx="42">
                  <c:v>2000</c:v>
                </c:pt>
                <c:pt idx="43">
                  <c:v>2001</c:v>
                </c:pt>
                <c:pt idx="44">
                  <c:v>2002</c:v>
                </c:pt>
                <c:pt idx="45">
                  <c:v>2003</c:v>
                </c:pt>
                <c:pt idx="46">
                  <c:v>2004</c:v>
                </c:pt>
                <c:pt idx="47">
                  <c:v>2005</c:v>
                </c:pt>
                <c:pt idx="48">
                  <c:v>2006</c:v>
                </c:pt>
                <c:pt idx="49">
                  <c:v>2007</c:v>
                </c:pt>
                <c:pt idx="50">
                  <c:v>2008</c:v>
                </c:pt>
                <c:pt idx="51">
                  <c:v>2009</c:v>
                </c:pt>
                <c:pt idx="52">
                  <c:v>2010</c:v>
                </c:pt>
                <c:pt idx="53" formatCode="@">
                  <c:v>2011</c:v>
                </c:pt>
                <c:pt idx="54">
                  <c:v>2012</c:v>
                </c:pt>
                <c:pt idx="55">
                  <c:v>2013</c:v>
                </c:pt>
                <c:pt idx="56">
                  <c:v>2014</c:v>
                </c:pt>
                <c:pt idx="57">
                  <c:v>2015</c:v>
                </c:pt>
                <c:pt idx="58">
                  <c:v>2016</c:v>
                </c:pt>
                <c:pt idx="59">
                  <c:v>2017</c:v>
                </c:pt>
                <c:pt idx="60">
                  <c:v>2018</c:v>
                </c:pt>
              </c:numCache>
            </c:numRef>
          </c:cat>
          <c:val>
            <c:numRef>
              <c:f>Sheet1!$D$2:$D$62</c:f>
              <c:numCache>
                <c:formatCode>0.0_ </c:formatCode>
                <c:ptCount val="61"/>
                <c:pt idx="0">
                  <c:v>9.4540866906000005</c:v>
                </c:pt>
                <c:pt idx="1">
                  <c:v>9.8365190336000001</c:v>
                </c:pt>
                <c:pt idx="2">
                  <c:v>9.4727798437999997</c:v>
                </c:pt>
                <c:pt idx="3">
                  <c:v>10.078492603000001</c:v>
                </c:pt>
                <c:pt idx="4">
                  <c:v>9.9952129410000001</c:v>
                </c:pt>
                <c:pt idx="5">
                  <c:v>10.466637817000001</c:v>
                </c:pt>
                <c:pt idx="6">
                  <c:v>10.970067449</c:v>
                </c:pt>
                <c:pt idx="7">
                  <c:v>11.291143656999999</c:v>
                </c:pt>
                <c:pt idx="8">
                  <c:v>11.170921451</c:v>
                </c:pt>
                <c:pt idx="9">
                  <c:v>11.69955983</c:v>
                </c:pt>
                <c:pt idx="10">
                  <c:v>12.395334675999999</c:v>
                </c:pt>
                <c:pt idx="11">
                  <c:v>12.710238474000001</c:v>
                </c:pt>
                <c:pt idx="12">
                  <c:v>13.000022314000001</c:v>
                </c:pt>
                <c:pt idx="13">
                  <c:v>13.377226788</c:v>
                </c:pt>
                <c:pt idx="14">
                  <c:v>13.750438795999999</c:v>
                </c:pt>
                <c:pt idx="15">
                  <c:v>14.713332813999999</c:v>
                </c:pt>
                <c:pt idx="16">
                  <c:v>15.531037283</c:v>
                </c:pt>
                <c:pt idx="17">
                  <c:v>15.257098085000001</c:v>
                </c:pt>
                <c:pt idx="18">
                  <c:v>15.989504584000001</c:v>
                </c:pt>
                <c:pt idx="19">
                  <c:v>16.278591116000001</c:v>
                </c:pt>
                <c:pt idx="20">
                  <c:v>16.454836201999999</c:v>
                </c:pt>
                <c:pt idx="21">
                  <c:v>17.232674397</c:v>
                </c:pt>
                <c:pt idx="22">
                  <c:v>17.679540574000001</c:v>
                </c:pt>
                <c:pt idx="23">
                  <c:v>18.340687793000001</c:v>
                </c:pt>
                <c:pt idx="24">
                  <c:v>18.524099324000002</c:v>
                </c:pt>
                <c:pt idx="25">
                  <c:v>18.783304421</c:v>
                </c:pt>
                <c:pt idx="26">
                  <c:v>19.450845972</c:v>
                </c:pt>
                <c:pt idx="27">
                  <c:v>19.875373107000001</c:v>
                </c:pt>
                <c:pt idx="28">
                  <c:v>20.028895602999999</c:v>
                </c:pt>
                <c:pt idx="29">
                  <c:v>20.620211274999999</c:v>
                </c:pt>
                <c:pt idx="30">
                  <c:v>20.841145641000001</c:v>
                </c:pt>
                <c:pt idx="31">
                  <c:v>21.555279367000001</c:v>
                </c:pt>
                <c:pt idx="32">
                  <c:v>22.051705304999999</c:v>
                </c:pt>
                <c:pt idx="33">
                  <c:v>22.266421113</c:v>
                </c:pt>
                <c:pt idx="34">
                  <c:v>23.116699081</c:v>
                </c:pt>
                <c:pt idx="35">
                  <c:v>22.978600920000002</c:v>
                </c:pt>
                <c:pt idx="36">
                  <c:v>23.060523048</c:v>
                </c:pt>
                <c:pt idx="37">
                  <c:v>24.439283958405372</c:v>
                </c:pt>
                <c:pt idx="38">
                  <c:v>24.714837442115599</c:v>
                </c:pt>
                <c:pt idx="39">
                  <c:v>24.241468251250627</c:v>
                </c:pt>
                <c:pt idx="40">
                  <c:v>24.379220050374418</c:v>
                </c:pt>
                <c:pt idx="41">
                  <c:v>24.150950300630992</c:v>
                </c:pt>
                <c:pt idx="42">
                  <c:v>23.719391095345522</c:v>
                </c:pt>
                <c:pt idx="43">
                  <c:v>23.441207387057759</c:v>
                </c:pt>
                <c:pt idx="44">
                  <c:v>22.991936249122769</c:v>
                </c:pt>
                <c:pt idx="45">
                  <c:v>22.818207952578021</c:v>
                </c:pt>
                <c:pt idx="46">
                  <c:v>23.041559981793615</c:v>
                </c:pt>
                <c:pt idx="47">
                  <c:v>22.443074528352057</c:v>
                </c:pt>
                <c:pt idx="48">
                  <c:v>22.122962603406279</c:v>
                </c:pt>
                <c:pt idx="49">
                  <c:v>21.888874731546785</c:v>
                </c:pt>
                <c:pt idx="50">
                  <c:v>21.737086664598486</c:v>
                </c:pt>
                <c:pt idx="51">
                  <c:v>20.540960867639892</c:v>
                </c:pt>
                <c:pt idx="52">
                  <c:v>21.032757937652601</c:v>
                </c:pt>
                <c:pt idx="53" formatCode="0.0_);[Red]\(0.0\)">
                  <c:v>21.435521654060135</c:v>
                </c:pt>
                <c:pt idx="54" formatCode="0.0">
                  <c:v>21.352055585731197</c:v>
                </c:pt>
                <c:pt idx="55" formatCode="0.0_);[Red]\(0.0\)">
                  <c:v>21.103923030345637</c:v>
                </c:pt>
                <c:pt idx="56" formatCode="0.0_);[Red]\(0.0\)">
                  <c:v>21.028391339566952</c:v>
                </c:pt>
                <c:pt idx="57" formatCode="0.0_);[Red]\(0.0\)">
                  <c:v>20.954478012348151</c:v>
                </c:pt>
                <c:pt idx="58" formatCode="0.0_);[Red]\(0.0\)">
                  <c:v>20.712369939498863</c:v>
                </c:pt>
                <c:pt idx="59" formatCode="0.0_);[Red]\(0.0\)">
                  <c:v>20.520120150778698</c:v>
                </c:pt>
                <c:pt idx="60" formatCode="0.0_);[Red]\(0.0\)">
                  <c:v>19.9652227202250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920-4B3F-9C94-DB0244CE5668}"/>
            </c:ext>
          </c:extLst>
        </c:ser>
        <c:ser>
          <c:idx val="3"/>
          <c:order val="2"/>
          <c:tx>
            <c:strRef>
              <c:f>Sheet1!$E$1</c:f>
              <c:strCache>
                <c:ptCount val="1"/>
                <c:pt idx="0">
                  <c:v>肝臓</c:v>
                </c:pt>
              </c:strCache>
            </c:strRef>
          </c:tx>
          <c:spPr>
            <a:ln w="38100" cap="rnd">
              <a:solidFill>
                <a:schemeClr val="accent4"/>
              </a:solidFill>
              <a:prstDash val="sysDot"/>
              <a:round/>
            </a:ln>
            <a:effectLst/>
          </c:spPr>
          <c:marker>
            <c:symbol val="none"/>
          </c:marker>
          <c:cat>
            <c:numRef>
              <c:f>Sheet1!$A$2:$A$62</c:f>
              <c:numCache>
                <c:formatCode>General</c:formatCode>
                <c:ptCount val="61"/>
                <c:pt idx="0">
                  <c:v>1958</c:v>
                </c:pt>
                <c:pt idx="1">
                  <c:v>1959</c:v>
                </c:pt>
                <c:pt idx="2">
                  <c:v>1960</c:v>
                </c:pt>
                <c:pt idx="3">
                  <c:v>1961</c:v>
                </c:pt>
                <c:pt idx="4">
                  <c:v>1962</c:v>
                </c:pt>
                <c:pt idx="5">
                  <c:v>1963</c:v>
                </c:pt>
                <c:pt idx="6">
                  <c:v>1964</c:v>
                </c:pt>
                <c:pt idx="7">
                  <c:v>1965</c:v>
                </c:pt>
                <c:pt idx="8">
                  <c:v>1966</c:v>
                </c:pt>
                <c:pt idx="9">
                  <c:v>1967</c:v>
                </c:pt>
                <c:pt idx="10">
                  <c:v>1968</c:v>
                </c:pt>
                <c:pt idx="11">
                  <c:v>1969</c:v>
                </c:pt>
                <c:pt idx="12">
                  <c:v>1970</c:v>
                </c:pt>
                <c:pt idx="13">
                  <c:v>1971</c:v>
                </c:pt>
                <c:pt idx="14">
                  <c:v>1972</c:v>
                </c:pt>
                <c:pt idx="15">
                  <c:v>1973</c:v>
                </c:pt>
                <c:pt idx="16">
                  <c:v>1974</c:v>
                </c:pt>
                <c:pt idx="17">
                  <c:v>1975</c:v>
                </c:pt>
                <c:pt idx="18">
                  <c:v>1976</c:v>
                </c:pt>
                <c:pt idx="19">
                  <c:v>1977</c:v>
                </c:pt>
                <c:pt idx="20">
                  <c:v>1978</c:v>
                </c:pt>
                <c:pt idx="21">
                  <c:v>1979</c:v>
                </c:pt>
                <c:pt idx="22">
                  <c:v>1980</c:v>
                </c:pt>
                <c:pt idx="23">
                  <c:v>1981</c:v>
                </c:pt>
                <c:pt idx="24">
                  <c:v>1982</c:v>
                </c:pt>
                <c:pt idx="25">
                  <c:v>1983</c:v>
                </c:pt>
                <c:pt idx="26">
                  <c:v>1984</c:v>
                </c:pt>
                <c:pt idx="27">
                  <c:v>1985</c:v>
                </c:pt>
                <c:pt idx="28">
                  <c:v>1986</c:v>
                </c:pt>
                <c:pt idx="29">
                  <c:v>1987</c:v>
                </c:pt>
                <c:pt idx="30">
                  <c:v>1988</c:v>
                </c:pt>
                <c:pt idx="31">
                  <c:v>1989</c:v>
                </c:pt>
                <c:pt idx="32">
                  <c:v>1990</c:v>
                </c:pt>
                <c:pt idx="33">
                  <c:v>1991</c:v>
                </c:pt>
                <c:pt idx="34">
                  <c:v>1992</c:v>
                </c:pt>
                <c:pt idx="35">
                  <c:v>1993</c:v>
                </c:pt>
                <c:pt idx="36">
                  <c:v>1994</c:v>
                </c:pt>
                <c:pt idx="37">
                  <c:v>1995</c:v>
                </c:pt>
                <c:pt idx="38">
                  <c:v>1996</c:v>
                </c:pt>
                <c:pt idx="39">
                  <c:v>1997</c:v>
                </c:pt>
                <c:pt idx="40">
                  <c:v>1998</c:v>
                </c:pt>
                <c:pt idx="41">
                  <c:v>1999</c:v>
                </c:pt>
                <c:pt idx="42">
                  <c:v>2000</c:v>
                </c:pt>
                <c:pt idx="43">
                  <c:v>2001</c:v>
                </c:pt>
                <c:pt idx="44">
                  <c:v>2002</c:v>
                </c:pt>
                <c:pt idx="45">
                  <c:v>2003</c:v>
                </c:pt>
                <c:pt idx="46">
                  <c:v>2004</c:v>
                </c:pt>
                <c:pt idx="47">
                  <c:v>2005</c:v>
                </c:pt>
                <c:pt idx="48">
                  <c:v>2006</c:v>
                </c:pt>
                <c:pt idx="49">
                  <c:v>2007</c:v>
                </c:pt>
                <c:pt idx="50">
                  <c:v>2008</c:v>
                </c:pt>
                <c:pt idx="51">
                  <c:v>2009</c:v>
                </c:pt>
                <c:pt idx="52">
                  <c:v>2010</c:v>
                </c:pt>
                <c:pt idx="53" formatCode="@">
                  <c:v>2011</c:v>
                </c:pt>
                <c:pt idx="54">
                  <c:v>2012</c:v>
                </c:pt>
                <c:pt idx="55">
                  <c:v>2013</c:v>
                </c:pt>
                <c:pt idx="56">
                  <c:v>2014</c:v>
                </c:pt>
                <c:pt idx="57">
                  <c:v>2015</c:v>
                </c:pt>
                <c:pt idx="58">
                  <c:v>2016</c:v>
                </c:pt>
                <c:pt idx="59">
                  <c:v>2017</c:v>
                </c:pt>
                <c:pt idx="60">
                  <c:v>2018</c:v>
                </c:pt>
              </c:numCache>
            </c:numRef>
          </c:cat>
          <c:val>
            <c:numRef>
              <c:f>Sheet1!$E$2:$E$62</c:f>
              <c:numCache>
                <c:formatCode>0.0_ </c:formatCode>
                <c:ptCount val="61"/>
                <c:pt idx="0">
                  <c:v>18.948268084999999</c:v>
                </c:pt>
                <c:pt idx="1">
                  <c:v>18.738557374999999</c:v>
                </c:pt>
                <c:pt idx="2">
                  <c:v>19.447873847</c:v>
                </c:pt>
                <c:pt idx="3">
                  <c:v>18.581683690999999</c:v>
                </c:pt>
                <c:pt idx="4">
                  <c:v>18.485286038999998</c:v>
                </c:pt>
                <c:pt idx="5">
                  <c:v>18.287160916000001</c:v>
                </c:pt>
                <c:pt idx="6">
                  <c:v>17.866004047000001</c:v>
                </c:pt>
                <c:pt idx="7">
                  <c:v>16.982720200999999</c:v>
                </c:pt>
                <c:pt idx="8">
                  <c:v>17.552562533</c:v>
                </c:pt>
                <c:pt idx="9">
                  <c:v>16.893158879000001</c:v>
                </c:pt>
                <c:pt idx="10">
                  <c:v>17.149092322000001</c:v>
                </c:pt>
                <c:pt idx="11">
                  <c:v>17.961778869</c:v>
                </c:pt>
                <c:pt idx="12">
                  <c:v>17.706328973000002</c:v>
                </c:pt>
                <c:pt idx="13">
                  <c:v>17.476543823</c:v>
                </c:pt>
                <c:pt idx="14">
                  <c:v>17.256267739999998</c:v>
                </c:pt>
                <c:pt idx="15">
                  <c:v>17.325652248000001</c:v>
                </c:pt>
                <c:pt idx="16">
                  <c:v>17.127351999999998</c:v>
                </c:pt>
                <c:pt idx="17">
                  <c:v>17.403187772999999</c:v>
                </c:pt>
                <c:pt idx="18">
                  <c:v>18.708052842000001</c:v>
                </c:pt>
                <c:pt idx="19">
                  <c:v>19.020147122000001</c:v>
                </c:pt>
                <c:pt idx="20">
                  <c:v>20.304185672999999</c:v>
                </c:pt>
                <c:pt idx="21">
                  <c:v>21.447713777000001</c:v>
                </c:pt>
                <c:pt idx="22">
                  <c:v>21.997624692999999</c:v>
                </c:pt>
                <c:pt idx="23">
                  <c:v>22.603635920999999</c:v>
                </c:pt>
                <c:pt idx="24">
                  <c:v>23.985986322999999</c:v>
                </c:pt>
                <c:pt idx="25">
                  <c:v>25.174889752999999</c:v>
                </c:pt>
                <c:pt idx="26">
                  <c:v>25.856057212</c:v>
                </c:pt>
                <c:pt idx="27">
                  <c:v>26.887847220000001</c:v>
                </c:pt>
                <c:pt idx="28">
                  <c:v>27.374354577999998</c:v>
                </c:pt>
                <c:pt idx="29">
                  <c:v>28.397911328999999</c:v>
                </c:pt>
                <c:pt idx="30">
                  <c:v>28.596873470999999</c:v>
                </c:pt>
                <c:pt idx="31">
                  <c:v>29.188936910999999</c:v>
                </c:pt>
                <c:pt idx="32">
                  <c:v>29.453144270999999</c:v>
                </c:pt>
                <c:pt idx="33">
                  <c:v>29.198571258000001</c:v>
                </c:pt>
                <c:pt idx="34">
                  <c:v>29.554462051000002</c:v>
                </c:pt>
                <c:pt idx="35">
                  <c:v>29.404956558999999</c:v>
                </c:pt>
                <c:pt idx="36">
                  <c:v>29.673603327999999</c:v>
                </c:pt>
                <c:pt idx="37">
                  <c:v>31.583700933999999</c:v>
                </c:pt>
                <c:pt idx="38">
                  <c:v>30.788121529000001</c:v>
                </c:pt>
                <c:pt idx="39">
                  <c:v>29.942710844</c:v>
                </c:pt>
                <c:pt idx="40">
                  <c:v>29.865546308999999</c:v>
                </c:pt>
                <c:pt idx="41">
                  <c:v>29.043645199</c:v>
                </c:pt>
                <c:pt idx="42">
                  <c:v>28.164924791000001</c:v>
                </c:pt>
                <c:pt idx="43">
                  <c:v>27.34414688</c:v>
                </c:pt>
                <c:pt idx="44">
                  <c:v>26.725952376999999</c:v>
                </c:pt>
                <c:pt idx="45">
                  <c:v>25.456124072000001</c:v>
                </c:pt>
                <c:pt idx="46">
                  <c:v>24.834076273000001</c:v>
                </c:pt>
                <c:pt idx="47">
                  <c:v>23.716784935</c:v>
                </c:pt>
                <c:pt idx="48">
                  <c:v>22.423617058000001</c:v>
                </c:pt>
                <c:pt idx="49">
                  <c:v>21.509715110999998</c:v>
                </c:pt>
                <c:pt idx="50">
                  <c:v>20.903874005999999</c:v>
                </c:pt>
                <c:pt idx="51">
                  <c:v>19.651763085999999</c:v>
                </c:pt>
                <c:pt idx="52">
                  <c:v>18.965286523</c:v>
                </c:pt>
                <c:pt idx="53" formatCode="0.0_);[Red]\(0.0\)">
                  <c:v>17.965221685660058</c:v>
                </c:pt>
                <c:pt idx="54" formatCode="0.0">
                  <c:v>16.745886598820547</c:v>
                </c:pt>
                <c:pt idx="55">
                  <c:v>16</c:v>
                </c:pt>
                <c:pt idx="56">
                  <c:v>15</c:v>
                </c:pt>
                <c:pt idx="57">
                  <c:v>14.5</c:v>
                </c:pt>
                <c:pt idx="58">
                  <c:v>13.7</c:v>
                </c:pt>
                <c:pt idx="59">
                  <c:v>12.8</c:v>
                </c:pt>
                <c:pt idx="60" formatCode="0.0_);[Red]\(0.0\)">
                  <c:v>11.81563611134737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7920-4B3F-9C94-DB0244CE5668}"/>
            </c:ext>
          </c:extLst>
        </c:ser>
        <c:ser>
          <c:idx val="6"/>
          <c:order val="3"/>
          <c:tx>
            <c:strRef>
              <c:f>Sheet1!$H$1</c:f>
              <c:strCache>
                <c:ptCount val="1"/>
                <c:pt idx="0">
                  <c:v>肺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Sheet1!$A$2:$A$62</c:f>
              <c:numCache>
                <c:formatCode>General</c:formatCode>
                <c:ptCount val="61"/>
                <c:pt idx="0">
                  <c:v>1958</c:v>
                </c:pt>
                <c:pt idx="1">
                  <c:v>1959</c:v>
                </c:pt>
                <c:pt idx="2">
                  <c:v>1960</c:v>
                </c:pt>
                <c:pt idx="3">
                  <c:v>1961</c:v>
                </c:pt>
                <c:pt idx="4">
                  <c:v>1962</c:v>
                </c:pt>
                <c:pt idx="5">
                  <c:v>1963</c:v>
                </c:pt>
                <c:pt idx="6">
                  <c:v>1964</c:v>
                </c:pt>
                <c:pt idx="7">
                  <c:v>1965</c:v>
                </c:pt>
                <c:pt idx="8">
                  <c:v>1966</c:v>
                </c:pt>
                <c:pt idx="9">
                  <c:v>1967</c:v>
                </c:pt>
                <c:pt idx="10">
                  <c:v>1968</c:v>
                </c:pt>
                <c:pt idx="11">
                  <c:v>1969</c:v>
                </c:pt>
                <c:pt idx="12">
                  <c:v>1970</c:v>
                </c:pt>
                <c:pt idx="13">
                  <c:v>1971</c:v>
                </c:pt>
                <c:pt idx="14">
                  <c:v>1972</c:v>
                </c:pt>
                <c:pt idx="15">
                  <c:v>1973</c:v>
                </c:pt>
                <c:pt idx="16">
                  <c:v>1974</c:v>
                </c:pt>
                <c:pt idx="17">
                  <c:v>1975</c:v>
                </c:pt>
                <c:pt idx="18">
                  <c:v>1976</c:v>
                </c:pt>
                <c:pt idx="19">
                  <c:v>1977</c:v>
                </c:pt>
                <c:pt idx="20">
                  <c:v>1978</c:v>
                </c:pt>
                <c:pt idx="21">
                  <c:v>1979</c:v>
                </c:pt>
                <c:pt idx="22">
                  <c:v>1980</c:v>
                </c:pt>
                <c:pt idx="23">
                  <c:v>1981</c:v>
                </c:pt>
                <c:pt idx="24">
                  <c:v>1982</c:v>
                </c:pt>
                <c:pt idx="25">
                  <c:v>1983</c:v>
                </c:pt>
                <c:pt idx="26">
                  <c:v>1984</c:v>
                </c:pt>
                <c:pt idx="27">
                  <c:v>1985</c:v>
                </c:pt>
                <c:pt idx="28">
                  <c:v>1986</c:v>
                </c:pt>
                <c:pt idx="29">
                  <c:v>1987</c:v>
                </c:pt>
                <c:pt idx="30">
                  <c:v>1988</c:v>
                </c:pt>
                <c:pt idx="31">
                  <c:v>1989</c:v>
                </c:pt>
                <c:pt idx="32">
                  <c:v>1990</c:v>
                </c:pt>
                <c:pt idx="33">
                  <c:v>1991</c:v>
                </c:pt>
                <c:pt idx="34">
                  <c:v>1992</c:v>
                </c:pt>
                <c:pt idx="35">
                  <c:v>1993</c:v>
                </c:pt>
                <c:pt idx="36">
                  <c:v>1994</c:v>
                </c:pt>
                <c:pt idx="37">
                  <c:v>1995</c:v>
                </c:pt>
                <c:pt idx="38">
                  <c:v>1996</c:v>
                </c:pt>
                <c:pt idx="39">
                  <c:v>1997</c:v>
                </c:pt>
                <c:pt idx="40">
                  <c:v>1998</c:v>
                </c:pt>
                <c:pt idx="41">
                  <c:v>1999</c:v>
                </c:pt>
                <c:pt idx="42">
                  <c:v>2000</c:v>
                </c:pt>
                <c:pt idx="43">
                  <c:v>2001</c:v>
                </c:pt>
                <c:pt idx="44">
                  <c:v>2002</c:v>
                </c:pt>
                <c:pt idx="45">
                  <c:v>2003</c:v>
                </c:pt>
                <c:pt idx="46">
                  <c:v>2004</c:v>
                </c:pt>
                <c:pt idx="47">
                  <c:v>2005</c:v>
                </c:pt>
                <c:pt idx="48">
                  <c:v>2006</c:v>
                </c:pt>
                <c:pt idx="49">
                  <c:v>2007</c:v>
                </c:pt>
                <c:pt idx="50">
                  <c:v>2008</c:v>
                </c:pt>
                <c:pt idx="51">
                  <c:v>2009</c:v>
                </c:pt>
                <c:pt idx="52">
                  <c:v>2010</c:v>
                </c:pt>
                <c:pt idx="53" formatCode="@">
                  <c:v>2011</c:v>
                </c:pt>
                <c:pt idx="54">
                  <c:v>2012</c:v>
                </c:pt>
                <c:pt idx="55">
                  <c:v>2013</c:v>
                </c:pt>
                <c:pt idx="56">
                  <c:v>2014</c:v>
                </c:pt>
                <c:pt idx="57">
                  <c:v>2015</c:v>
                </c:pt>
                <c:pt idx="58">
                  <c:v>2016</c:v>
                </c:pt>
                <c:pt idx="59">
                  <c:v>2017</c:v>
                </c:pt>
                <c:pt idx="60">
                  <c:v>2018</c:v>
                </c:pt>
              </c:numCache>
            </c:numRef>
          </c:cat>
          <c:val>
            <c:numRef>
              <c:f>Sheet1!$H$2:$H$62</c:f>
              <c:numCache>
                <c:formatCode>0.0_ </c:formatCode>
                <c:ptCount val="61"/>
                <c:pt idx="0">
                  <c:v>11.327859232</c:v>
                </c:pt>
                <c:pt idx="1">
                  <c:v>12.634719284999999</c:v>
                </c:pt>
                <c:pt idx="2">
                  <c:v>13.593572089</c:v>
                </c:pt>
                <c:pt idx="3">
                  <c:v>14.288414462</c:v>
                </c:pt>
                <c:pt idx="4">
                  <c:v>15.377132013000001</c:v>
                </c:pt>
                <c:pt idx="5">
                  <c:v>16.539027778000001</c:v>
                </c:pt>
                <c:pt idx="6">
                  <c:v>17.336271912000001</c:v>
                </c:pt>
                <c:pt idx="7">
                  <c:v>18.134208965999999</c:v>
                </c:pt>
                <c:pt idx="8">
                  <c:v>19.126672118999998</c:v>
                </c:pt>
                <c:pt idx="9">
                  <c:v>20.208066618</c:v>
                </c:pt>
                <c:pt idx="10">
                  <c:v>20.873177699999999</c:v>
                </c:pt>
                <c:pt idx="11">
                  <c:v>22.173830861999999</c:v>
                </c:pt>
                <c:pt idx="12">
                  <c:v>22.471513979000001</c:v>
                </c:pt>
                <c:pt idx="13">
                  <c:v>23.632380073</c:v>
                </c:pt>
                <c:pt idx="14">
                  <c:v>25.349252359000001</c:v>
                </c:pt>
                <c:pt idx="15">
                  <c:v>25.846209123000001</c:v>
                </c:pt>
                <c:pt idx="16">
                  <c:v>27.202793777</c:v>
                </c:pt>
                <c:pt idx="17">
                  <c:v>28.069508510999999</c:v>
                </c:pt>
                <c:pt idx="18">
                  <c:v>29.578314680999998</c:v>
                </c:pt>
                <c:pt idx="19">
                  <c:v>31.293029864000001</c:v>
                </c:pt>
                <c:pt idx="20">
                  <c:v>32.533908560999997</c:v>
                </c:pt>
                <c:pt idx="21">
                  <c:v>34.452275450999998</c:v>
                </c:pt>
                <c:pt idx="22">
                  <c:v>35.493297229</c:v>
                </c:pt>
                <c:pt idx="23">
                  <c:v>37.182881477000002</c:v>
                </c:pt>
                <c:pt idx="24">
                  <c:v>38.022828521000001</c:v>
                </c:pt>
                <c:pt idx="25">
                  <c:v>39.272979817</c:v>
                </c:pt>
                <c:pt idx="26">
                  <c:v>40.664911373999999</c:v>
                </c:pt>
                <c:pt idx="27">
                  <c:v>41.478289777999997</c:v>
                </c:pt>
                <c:pt idx="28">
                  <c:v>41.081046751000002</c:v>
                </c:pt>
                <c:pt idx="29">
                  <c:v>42.803202313</c:v>
                </c:pt>
                <c:pt idx="30">
                  <c:v>43.699202706999998</c:v>
                </c:pt>
                <c:pt idx="31">
                  <c:v>44.986672873000003</c:v>
                </c:pt>
                <c:pt idx="32">
                  <c:v>45.006191661000003</c:v>
                </c:pt>
                <c:pt idx="33">
                  <c:v>45.341834349999999</c:v>
                </c:pt>
                <c:pt idx="34">
                  <c:v>45.800817029999997</c:v>
                </c:pt>
                <c:pt idx="35">
                  <c:v>46.148807476999998</c:v>
                </c:pt>
                <c:pt idx="36">
                  <c:v>46.693386214</c:v>
                </c:pt>
                <c:pt idx="37">
                  <c:v>47.472012822000003</c:v>
                </c:pt>
                <c:pt idx="38">
                  <c:v>48.103937223999999</c:v>
                </c:pt>
                <c:pt idx="39">
                  <c:v>47.312445750999998</c:v>
                </c:pt>
                <c:pt idx="40">
                  <c:v>47.294568671</c:v>
                </c:pt>
                <c:pt idx="41">
                  <c:v>47.026241540999997</c:v>
                </c:pt>
                <c:pt idx="42">
                  <c:v>46.338619373</c:v>
                </c:pt>
                <c:pt idx="43">
                  <c:v>45.557108311999997</c:v>
                </c:pt>
                <c:pt idx="44">
                  <c:v>45.299958846999999</c:v>
                </c:pt>
                <c:pt idx="45">
                  <c:v>44.212464337999997</c:v>
                </c:pt>
                <c:pt idx="46">
                  <c:v>45.150046519</c:v>
                </c:pt>
                <c:pt idx="47">
                  <c:v>44.615783647000001</c:v>
                </c:pt>
                <c:pt idx="48">
                  <c:v>44.003354106000003</c:v>
                </c:pt>
                <c:pt idx="49">
                  <c:v>43.979689985999997</c:v>
                </c:pt>
                <c:pt idx="50">
                  <c:v>43.512261733999999</c:v>
                </c:pt>
                <c:pt idx="51">
                  <c:v>42.468820033999997</c:v>
                </c:pt>
                <c:pt idx="52">
                  <c:v>42.436780396000003</c:v>
                </c:pt>
                <c:pt idx="53" formatCode="0.0_);[Red]\(0.0\)">
                  <c:v>41.712913295677694</c:v>
                </c:pt>
                <c:pt idx="54" formatCode="0.0">
                  <c:v>40.974448978436506</c:v>
                </c:pt>
                <c:pt idx="55" formatCode="0.0_);[Red]\(0.0\)">
                  <c:v>40.416419457671395</c:v>
                </c:pt>
                <c:pt idx="56" formatCode="0.0_);[Red]\(0.0\)">
                  <c:v>39.660920517122321</c:v>
                </c:pt>
                <c:pt idx="57" formatCode="0.0_);[Red]\(0.0\)">
                  <c:v>39.164732853111381</c:v>
                </c:pt>
                <c:pt idx="58" formatCode="0.0_);[Red]\(0.0\)">
                  <c:v>37.61138686984237</c:v>
                </c:pt>
                <c:pt idx="59" formatCode="0.0_);[Red]\(0.0\)">
                  <c:v>36.783720372966641</c:v>
                </c:pt>
                <c:pt idx="60">
                  <c:v>35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7920-4B3F-9C94-DB0244CE5668}"/>
            </c:ext>
          </c:extLst>
        </c:ser>
        <c:ser>
          <c:idx val="7"/>
          <c:order val="4"/>
          <c:tx>
            <c:strRef>
              <c:f>Sheet1!$I$1</c:f>
              <c:strCache>
                <c:ptCount val="1"/>
                <c:pt idx="0">
                  <c:v>前立腺</c:v>
                </c:pt>
              </c:strCache>
            </c:strRef>
          </c:tx>
          <c:spPr>
            <a:ln w="381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Sheet1!$A$2:$A$62</c:f>
              <c:numCache>
                <c:formatCode>General</c:formatCode>
                <c:ptCount val="61"/>
                <c:pt idx="0">
                  <c:v>1958</c:v>
                </c:pt>
                <c:pt idx="1">
                  <c:v>1959</c:v>
                </c:pt>
                <c:pt idx="2">
                  <c:v>1960</c:v>
                </c:pt>
                <c:pt idx="3">
                  <c:v>1961</c:v>
                </c:pt>
                <c:pt idx="4">
                  <c:v>1962</c:v>
                </c:pt>
                <c:pt idx="5">
                  <c:v>1963</c:v>
                </c:pt>
                <c:pt idx="6">
                  <c:v>1964</c:v>
                </c:pt>
                <c:pt idx="7">
                  <c:v>1965</c:v>
                </c:pt>
                <c:pt idx="8">
                  <c:v>1966</c:v>
                </c:pt>
                <c:pt idx="9">
                  <c:v>1967</c:v>
                </c:pt>
                <c:pt idx="10">
                  <c:v>1968</c:v>
                </c:pt>
                <c:pt idx="11">
                  <c:v>1969</c:v>
                </c:pt>
                <c:pt idx="12">
                  <c:v>1970</c:v>
                </c:pt>
                <c:pt idx="13">
                  <c:v>1971</c:v>
                </c:pt>
                <c:pt idx="14">
                  <c:v>1972</c:v>
                </c:pt>
                <c:pt idx="15">
                  <c:v>1973</c:v>
                </c:pt>
                <c:pt idx="16">
                  <c:v>1974</c:v>
                </c:pt>
                <c:pt idx="17">
                  <c:v>1975</c:v>
                </c:pt>
                <c:pt idx="18">
                  <c:v>1976</c:v>
                </c:pt>
                <c:pt idx="19">
                  <c:v>1977</c:v>
                </c:pt>
                <c:pt idx="20">
                  <c:v>1978</c:v>
                </c:pt>
                <c:pt idx="21">
                  <c:v>1979</c:v>
                </c:pt>
                <c:pt idx="22">
                  <c:v>1980</c:v>
                </c:pt>
                <c:pt idx="23">
                  <c:v>1981</c:v>
                </c:pt>
                <c:pt idx="24">
                  <c:v>1982</c:v>
                </c:pt>
                <c:pt idx="25">
                  <c:v>1983</c:v>
                </c:pt>
                <c:pt idx="26">
                  <c:v>1984</c:v>
                </c:pt>
                <c:pt idx="27">
                  <c:v>1985</c:v>
                </c:pt>
                <c:pt idx="28">
                  <c:v>1986</c:v>
                </c:pt>
                <c:pt idx="29">
                  <c:v>1987</c:v>
                </c:pt>
                <c:pt idx="30">
                  <c:v>1988</c:v>
                </c:pt>
                <c:pt idx="31">
                  <c:v>1989</c:v>
                </c:pt>
                <c:pt idx="32">
                  <c:v>1990</c:v>
                </c:pt>
                <c:pt idx="33">
                  <c:v>1991</c:v>
                </c:pt>
                <c:pt idx="34">
                  <c:v>1992</c:v>
                </c:pt>
                <c:pt idx="35">
                  <c:v>1993</c:v>
                </c:pt>
                <c:pt idx="36">
                  <c:v>1994</c:v>
                </c:pt>
                <c:pt idx="37">
                  <c:v>1995</c:v>
                </c:pt>
                <c:pt idx="38">
                  <c:v>1996</c:v>
                </c:pt>
                <c:pt idx="39">
                  <c:v>1997</c:v>
                </c:pt>
                <c:pt idx="40">
                  <c:v>1998</c:v>
                </c:pt>
                <c:pt idx="41">
                  <c:v>1999</c:v>
                </c:pt>
                <c:pt idx="42">
                  <c:v>2000</c:v>
                </c:pt>
                <c:pt idx="43">
                  <c:v>2001</c:v>
                </c:pt>
                <c:pt idx="44">
                  <c:v>2002</c:v>
                </c:pt>
                <c:pt idx="45">
                  <c:v>2003</c:v>
                </c:pt>
                <c:pt idx="46">
                  <c:v>2004</c:v>
                </c:pt>
                <c:pt idx="47">
                  <c:v>2005</c:v>
                </c:pt>
                <c:pt idx="48">
                  <c:v>2006</c:v>
                </c:pt>
                <c:pt idx="49">
                  <c:v>2007</c:v>
                </c:pt>
                <c:pt idx="50">
                  <c:v>2008</c:v>
                </c:pt>
                <c:pt idx="51">
                  <c:v>2009</c:v>
                </c:pt>
                <c:pt idx="52">
                  <c:v>2010</c:v>
                </c:pt>
                <c:pt idx="53" formatCode="@">
                  <c:v>2011</c:v>
                </c:pt>
                <c:pt idx="54">
                  <c:v>2012</c:v>
                </c:pt>
                <c:pt idx="55">
                  <c:v>2013</c:v>
                </c:pt>
                <c:pt idx="56">
                  <c:v>2014</c:v>
                </c:pt>
                <c:pt idx="57">
                  <c:v>2015</c:v>
                </c:pt>
                <c:pt idx="58">
                  <c:v>2016</c:v>
                </c:pt>
                <c:pt idx="59">
                  <c:v>2017</c:v>
                </c:pt>
                <c:pt idx="60">
                  <c:v>2018</c:v>
                </c:pt>
              </c:numCache>
            </c:numRef>
          </c:cat>
          <c:val>
            <c:numRef>
              <c:f>Sheet1!$I$2:$I$62</c:f>
              <c:numCache>
                <c:formatCode>0.0_ </c:formatCode>
                <c:ptCount val="61"/>
                <c:pt idx="0">
                  <c:v>2.1241519481000002</c:v>
                </c:pt>
                <c:pt idx="1">
                  <c:v>2.1728350673999999</c:v>
                </c:pt>
                <c:pt idx="2">
                  <c:v>2.2129614511</c:v>
                </c:pt>
                <c:pt idx="3">
                  <c:v>2.2743230849999998</c:v>
                </c:pt>
                <c:pt idx="4">
                  <c:v>2.5396675913000002</c:v>
                </c:pt>
                <c:pt idx="5">
                  <c:v>2.5820915485000002</c:v>
                </c:pt>
                <c:pt idx="6">
                  <c:v>3.0342686081000001</c:v>
                </c:pt>
                <c:pt idx="7">
                  <c:v>2.7656752997999998</c:v>
                </c:pt>
                <c:pt idx="8">
                  <c:v>2.9440732908</c:v>
                </c:pt>
                <c:pt idx="9">
                  <c:v>2.8666459567999998</c:v>
                </c:pt>
                <c:pt idx="10">
                  <c:v>3.1406492571000002</c:v>
                </c:pt>
                <c:pt idx="11">
                  <c:v>3.4233601847999999</c:v>
                </c:pt>
                <c:pt idx="12">
                  <c:v>3.2183923687</c:v>
                </c:pt>
                <c:pt idx="13">
                  <c:v>3.0070945813000001</c:v>
                </c:pt>
                <c:pt idx="14">
                  <c:v>3.2831588788000001</c:v>
                </c:pt>
                <c:pt idx="15">
                  <c:v>3.6283057052999999</c:v>
                </c:pt>
                <c:pt idx="16">
                  <c:v>3.6943139056000001</c:v>
                </c:pt>
                <c:pt idx="17">
                  <c:v>3.7978637775999999</c:v>
                </c:pt>
                <c:pt idx="18">
                  <c:v>3.7704222768000002</c:v>
                </c:pt>
                <c:pt idx="19">
                  <c:v>4.0806459887999997</c:v>
                </c:pt>
                <c:pt idx="20">
                  <c:v>4.0412538422999997</c:v>
                </c:pt>
                <c:pt idx="21">
                  <c:v>4.3610217109000002</c:v>
                </c:pt>
                <c:pt idx="22">
                  <c:v>4.3768379585000003</c:v>
                </c:pt>
                <c:pt idx="23">
                  <c:v>4.5709384771000003</c:v>
                </c:pt>
                <c:pt idx="24">
                  <c:v>4.8162845794000004</c:v>
                </c:pt>
                <c:pt idx="25">
                  <c:v>4.9137666177000003</c:v>
                </c:pt>
                <c:pt idx="26">
                  <c:v>5.0654969589999999</c:v>
                </c:pt>
                <c:pt idx="27">
                  <c:v>5.5976320052000004</c:v>
                </c:pt>
                <c:pt idx="28">
                  <c:v>5.5692927650000001</c:v>
                </c:pt>
                <c:pt idx="29">
                  <c:v>5.7563074419999998</c:v>
                </c:pt>
                <c:pt idx="30">
                  <c:v>5.6730483801</c:v>
                </c:pt>
                <c:pt idx="31">
                  <c:v>6.1341310177999997</c:v>
                </c:pt>
                <c:pt idx="32">
                  <c:v>5.9743455354000004</c:v>
                </c:pt>
                <c:pt idx="33">
                  <c:v>6.3942871737000004</c:v>
                </c:pt>
                <c:pt idx="34">
                  <c:v>6.5259621488999997</c:v>
                </c:pt>
                <c:pt idx="35">
                  <c:v>6.5949682546000004</c:v>
                </c:pt>
                <c:pt idx="36">
                  <c:v>7.0404250008</c:v>
                </c:pt>
                <c:pt idx="37">
                  <c:v>7.7308164667000003</c:v>
                </c:pt>
                <c:pt idx="38">
                  <c:v>8.2314604440999997</c:v>
                </c:pt>
                <c:pt idx="39">
                  <c:v>8.2074553265999999</c:v>
                </c:pt>
                <c:pt idx="40">
                  <c:v>8.6061405187000002</c:v>
                </c:pt>
                <c:pt idx="41">
                  <c:v>8.5112757046999992</c:v>
                </c:pt>
                <c:pt idx="42">
                  <c:v>8.6271974886000002</c:v>
                </c:pt>
                <c:pt idx="43">
                  <c:v>8.3662671177999997</c:v>
                </c:pt>
                <c:pt idx="44">
                  <c:v>8.4903040838999999</c:v>
                </c:pt>
                <c:pt idx="45">
                  <c:v>8.4541641545000008</c:v>
                </c:pt>
                <c:pt idx="46">
                  <c:v>8.5324140552000003</c:v>
                </c:pt>
                <c:pt idx="47">
                  <c:v>8.5179361300000007</c:v>
                </c:pt>
                <c:pt idx="48">
                  <c:v>8.3722725364000006</c:v>
                </c:pt>
                <c:pt idx="49">
                  <c:v>8.2165460650999993</c:v>
                </c:pt>
                <c:pt idx="50">
                  <c:v>8.0535104972999996</c:v>
                </c:pt>
                <c:pt idx="51">
                  <c:v>7.7444358898000001</c:v>
                </c:pt>
                <c:pt idx="52">
                  <c:v>7.9825398625000004</c:v>
                </c:pt>
                <c:pt idx="53" formatCode="0.0_);[Red]\(0.0\)">
                  <c:v>7.7866556980091586</c:v>
                </c:pt>
                <c:pt idx="54" formatCode="0.0">
                  <c:v>7.6365159271213416</c:v>
                </c:pt>
                <c:pt idx="55" formatCode="0.0_);[Red]\(0.0\)">
                  <c:v>7.6778428916875816</c:v>
                </c:pt>
                <c:pt idx="56" formatCode="0.0_);[Red]\(0.0\)">
                  <c:v>7.3178125709278401</c:v>
                </c:pt>
                <c:pt idx="57" formatCode="0.0_);[Red]\(0.0\)">
                  <c:v>6.9923632000709732</c:v>
                </c:pt>
                <c:pt idx="58" formatCode="0.0_);[Red]\(0.0\)">
                  <c:v>7.0520868609735698</c:v>
                </c:pt>
                <c:pt idx="59" formatCode="0.0_);[Red]\(0.0\)">
                  <c:v>6.9261526272141456</c:v>
                </c:pt>
                <c:pt idx="60">
                  <c:v>6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BD0-4ECE-BA91-7726487601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03505184"/>
        <c:axId val="303511168"/>
      </c:lineChart>
      <c:catAx>
        <c:axId val="3035051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cap="none" spc="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03511168"/>
        <c:crosses val="autoZero"/>
        <c:auto val="1"/>
        <c:lblAlgn val="ctr"/>
        <c:lblOffset val="100"/>
        <c:tickLblSkip val="2"/>
        <c:tickMarkSkip val="1"/>
        <c:noMultiLvlLbl val="0"/>
      </c:catAx>
      <c:valAx>
        <c:axId val="303511168"/>
        <c:scaling>
          <c:logBase val="10"/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numFmt formatCode="0.0_ 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035051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200" b="0" i="0" u="none" strike="noStrike" kern="1200" cap="none" spc="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  <a:ea typeface="+mj-ea"/>
                <a:cs typeface="+mj-cs"/>
              </a:defRPr>
            </a:pPr>
            <a:r>
              <a:rPr lang="en-US" altLang="ja-JP" dirty="0"/>
              <a:t>Females</a:t>
            </a:r>
            <a:endParaRPr lang="ja-JP" dirty="0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lineChart>
        <c:grouping val="standard"/>
        <c:varyColors val="0"/>
        <c:ser>
          <c:idx val="1"/>
          <c:order val="0"/>
          <c:tx>
            <c:strRef>
              <c:f>Sheet1!$C$1</c:f>
              <c:strCache>
                <c:ptCount val="1"/>
                <c:pt idx="0">
                  <c:v>胃</c:v>
                </c:pt>
              </c:strCache>
            </c:strRef>
          </c:tx>
          <c:spPr>
            <a:ln w="3810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Sheet1!$A$2:$A$62</c:f>
              <c:numCache>
                <c:formatCode>General</c:formatCode>
                <c:ptCount val="61"/>
                <c:pt idx="0">
                  <c:v>1958</c:v>
                </c:pt>
                <c:pt idx="1">
                  <c:v>1959</c:v>
                </c:pt>
                <c:pt idx="2">
                  <c:v>1960</c:v>
                </c:pt>
                <c:pt idx="3">
                  <c:v>1961</c:v>
                </c:pt>
                <c:pt idx="4">
                  <c:v>1962</c:v>
                </c:pt>
                <c:pt idx="5">
                  <c:v>1963</c:v>
                </c:pt>
                <c:pt idx="6">
                  <c:v>1964</c:v>
                </c:pt>
                <c:pt idx="7">
                  <c:v>1965</c:v>
                </c:pt>
                <c:pt idx="8">
                  <c:v>1966</c:v>
                </c:pt>
                <c:pt idx="9">
                  <c:v>1967</c:v>
                </c:pt>
                <c:pt idx="10">
                  <c:v>1968</c:v>
                </c:pt>
                <c:pt idx="11">
                  <c:v>1969</c:v>
                </c:pt>
                <c:pt idx="12">
                  <c:v>1970</c:v>
                </c:pt>
                <c:pt idx="13">
                  <c:v>1971</c:v>
                </c:pt>
                <c:pt idx="14">
                  <c:v>1972</c:v>
                </c:pt>
                <c:pt idx="15">
                  <c:v>1973</c:v>
                </c:pt>
                <c:pt idx="16">
                  <c:v>1974</c:v>
                </c:pt>
                <c:pt idx="17">
                  <c:v>1975</c:v>
                </c:pt>
                <c:pt idx="18">
                  <c:v>1976</c:v>
                </c:pt>
                <c:pt idx="19">
                  <c:v>1977</c:v>
                </c:pt>
                <c:pt idx="20">
                  <c:v>1978</c:v>
                </c:pt>
                <c:pt idx="21">
                  <c:v>1979</c:v>
                </c:pt>
                <c:pt idx="22">
                  <c:v>1980</c:v>
                </c:pt>
                <c:pt idx="23">
                  <c:v>1981</c:v>
                </c:pt>
                <c:pt idx="24">
                  <c:v>1982</c:v>
                </c:pt>
                <c:pt idx="25">
                  <c:v>1983</c:v>
                </c:pt>
                <c:pt idx="26">
                  <c:v>1984</c:v>
                </c:pt>
                <c:pt idx="27">
                  <c:v>1985</c:v>
                </c:pt>
                <c:pt idx="28">
                  <c:v>1986</c:v>
                </c:pt>
                <c:pt idx="29">
                  <c:v>1987</c:v>
                </c:pt>
                <c:pt idx="30">
                  <c:v>1988</c:v>
                </c:pt>
                <c:pt idx="31">
                  <c:v>1989</c:v>
                </c:pt>
                <c:pt idx="32">
                  <c:v>1990</c:v>
                </c:pt>
                <c:pt idx="33">
                  <c:v>1991</c:v>
                </c:pt>
                <c:pt idx="34">
                  <c:v>1992</c:v>
                </c:pt>
                <c:pt idx="35">
                  <c:v>1993</c:v>
                </c:pt>
                <c:pt idx="36">
                  <c:v>1994</c:v>
                </c:pt>
                <c:pt idx="37">
                  <c:v>1995</c:v>
                </c:pt>
                <c:pt idx="38">
                  <c:v>1996</c:v>
                </c:pt>
                <c:pt idx="39">
                  <c:v>1997</c:v>
                </c:pt>
                <c:pt idx="40">
                  <c:v>1998</c:v>
                </c:pt>
                <c:pt idx="41">
                  <c:v>1999</c:v>
                </c:pt>
                <c:pt idx="42">
                  <c:v>2000</c:v>
                </c:pt>
                <c:pt idx="43">
                  <c:v>2001</c:v>
                </c:pt>
                <c:pt idx="44">
                  <c:v>2002</c:v>
                </c:pt>
                <c:pt idx="45">
                  <c:v>2003</c:v>
                </c:pt>
                <c:pt idx="46">
                  <c:v>2004</c:v>
                </c:pt>
                <c:pt idx="47">
                  <c:v>2005</c:v>
                </c:pt>
                <c:pt idx="48">
                  <c:v>2006</c:v>
                </c:pt>
                <c:pt idx="49">
                  <c:v>2007</c:v>
                </c:pt>
                <c:pt idx="50">
                  <c:v>2008</c:v>
                </c:pt>
                <c:pt idx="51">
                  <c:v>2009</c:v>
                </c:pt>
                <c:pt idx="52">
                  <c:v>2010</c:v>
                </c:pt>
                <c:pt idx="53" formatCode="@">
                  <c:v>2011</c:v>
                </c:pt>
                <c:pt idx="54">
                  <c:v>2012</c:v>
                </c:pt>
                <c:pt idx="55">
                  <c:v>2013</c:v>
                </c:pt>
                <c:pt idx="56">
                  <c:v>2014</c:v>
                </c:pt>
                <c:pt idx="57">
                  <c:v>2015</c:v>
                </c:pt>
                <c:pt idx="58">
                  <c:v>2016</c:v>
                </c:pt>
                <c:pt idx="59">
                  <c:v>2017</c:v>
                </c:pt>
                <c:pt idx="60">
                  <c:v>2018</c:v>
                </c:pt>
              </c:numCache>
            </c:numRef>
          </c:cat>
          <c:val>
            <c:numRef>
              <c:f>Sheet1!$C$2:$C$62</c:f>
              <c:numCache>
                <c:formatCode>0.0_ </c:formatCode>
                <c:ptCount val="61"/>
                <c:pt idx="0">
                  <c:v>51.300916610999998</c:v>
                </c:pt>
                <c:pt idx="1">
                  <c:v>51.893545822999997</c:v>
                </c:pt>
                <c:pt idx="2">
                  <c:v>51.836995021</c:v>
                </c:pt>
                <c:pt idx="3">
                  <c:v>51.227311323999999</c:v>
                </c:pt>
                <c:pt idx="4">
                  <c:v>50.366027309000003</c:v>
                </c:pt>
                <c:pt idx="5">
                  <c:v>50.298095269000001</c:v>
                </c:pt>
                <c:pt idx="6">
                  <c:v>49.537353768999999</c:v>
                </c:pt>
                <c:pt idx="7">
                  <c:v>49.372412642</c:v>
                </c:pt>
                <c:pt idx="8">
                  <c:v>48.270146083</c:v>
                </c:pt>
                <c:pt idx="9">
                  <c:v>48.749330638000004</c:v>
                </c:pt>
                <c:pt idx="10">
                  <c:v>49.390715653000001</c:v>
                </c:pt>
                <c:pt idx="11">
                  <c:v>47.911979447999997</c:v>
                </c:pt>
                <c:pt idx="12">
                  <c:v>46.457917221999999</c:v>
                </c:pt>
                <c:pt idx="13">
                  <c:v>45.821937847999997</c:v>
                </c:pt>
                <c:pt idx="14">
                  <c:v>44.530772046000003</c:v>
                </c:pt>
                <c:pt idx="15">
                  <c:v>43.984140983000003</c:v>
                </c:pt>
                <c:pt idx="16">
                  <c:v>42.170259430999998</c:v>
                </c:pt>
                <c:pt idx="17">
                  <c:v>39.772132528999997</c:v>
                </c:pt>
                <c:pt idx="18">
                  <c:v>38.873783903000003</c:v>
                </c:pt>
                <c:pt idx="19">
                  <c:v>38.008258437999999</c:v>
                </c:pt>
                <c:pt idx="20">
                  <c:v>36.058056737999998</c:v>
                </c:pt>
                <c:pt idx="21">
                  <c:v>35.665358408000003</c:v>
                </c:pt>
                <c:pt idx="22">
                  <c:v>34.078924821999998</c:v>
                </c:pt>
                <c:pt idx="23">
                  <c:v>32.428679144</c:v>
                </c:pt>
                <c:pt idx="24">
                  <c:v>30.866419214</c:v>
                </c:pt>
                <c:pt idx="25">
                  <c:v>29.534575092000001</c:v>
                </c:pt>
                <c:pt idx="26">
                  <c:v>28.777296826000001</c:v>
                </c:pt>
                <c:pt idx="27">
                  <c:v>27.532579543000001</c:v>
                </c:pt>
                <c:pt idx="28">
                  <c:v>25.672462826</c:v>
                </c:pt>
                <c:pt idx="29">
                  <c:v>24.685010965</c:v>
                </c:pt>
                <c:pt idx="30">
                  <c:v>23.676806040999999</c:v>
                </c:pt>
                <c:pt idx="31">
                  <c:v>22.881462192000001</c:v>
                </c:pt>
                <c:pt idx="32">
                  <c:v>21.555821953999999</c:v>
                </c:pt>
                <c:pt idx="33">
                  <c:v>20.930668978</c:v>
                </c:pt>
                <c:pt idx="34">
                  <c:v>20.143791720999999</c:v>
                </c:pt>
                <c:pt idx="35">
                  <c:v>19.196421443999999</c:v>
                </c:pt>
                <c:pt idx="36">
                  <c:v>18.360738987000001</c:v>
                </c:pt>
                <c:pt idx="37">
                  <c:v>18.539866050000001</c:v>
                </c:pt>
                <c:pt idx="38">
                  <c:v>17.605292297999998</c:v>
                </c:pt>
                <c:pt idx="39">
                  <c:v>16.767261892000001</c:v>
                </c:pt>
                <c:pt idx="40">
                  <c:v>16.410294011000001</c:v>
                </c:pt>
                <c:pt idx="41">
                  <c:v>15.93631033</c:v>
                </c:pt>
                <c:pt idx="42">
                  <c:v>15.340630693</c:v>
                </c:pt>
                <c:pt idx="43">
                  <c:v>14.594137249999999</c:v>
                </c:pt>
                <c:pt idx="44">
                  <c:v>13.812854227000001</c:v>
                </c:pt>
                <c:pt idx="45">
                  <c:v>13.190159419</c:v>
                </c:pt>
                <c:pt idx="46">
                  <c:v>13.153812285000001</c:v>
                </c:pt>
                <c:pt idx="47">
                  <c:v>12.462227894</c:v>
                </c:pt>
                <c:pt idx="48">
                  <c:v>12.021257844000001</c:v>
                </c:pt>
                <c:pt idx="49">
                  <c:v>11.524573916</c:v>
                </c:pt>
                <c:pt idx="50">
                  <c:v>11.029453169</c:v>
                </c:pt>
                <c:pt idx="51">
                  <c:v>10.673839125000001</c:v>
                </c:pt>
                <c:pt idx="52">
                  <c:v>10.231700407</c:v>
                </c:pt>
                <c:pt idx="53" formatCode="0.0_);[Red]\(0.0\)">
                  <c:v>9.909214615952374</c:v>
                </c:pt>
                <c:pt idx="54" formatCode="0.0">
                  <c:v>9.5656547902804832</c:v>
                </c:pt>
                <c:pt idx="55" formatCode="General">
                  <c:v>9.1999999999999993</c:v>
                </c:pt>
                <c:pt idx="56" formatCode="General">
                  <c:v>9</c:v>
                </c:pt>
                <c:pt idx="57" formatCode="General">
                  <c:v>8.3000000000000007</c:v>
                </c:pt>
                <c:pt idx="58" formatCode="General">
                  <c:v>8</c:v>
                </c:pt>
                <c:pt idx="59" formatCode="General">
                  <c:v>7.6</c:v>
                </c:pt>
                <c:pt idx="60" formatCode="0.0_);[Red]\(0.0\)">
                  <c:v>7.35442787629954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4EA-41B3-8532-411722C3D2D3}"/>
            </c:ext>
          </c:extLst>
        </c:ser>
        <c:ser>
          <c:idx val="2"/>
          <c:order val="1"/>
          <c:tx>
            <c:strRef>
              <c:f>Sheet1!$D$1</c:f>
              <c:strCache>
                <c:ptCount val="1"/>
                <c:pt idx="0">
                  <c:v>大腸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Sheet1!$A$2:$A$62</c:f>
              <c:numCache>
                <c:formatCode>General</c:formatCode>
                <c:ptCount val="61"/>
                <c:pt idx="0">
                  <c:v>1958</c:v>
                </c:pt>
                <c:pt idx="1">
                  <c:v>1959</c:v>
                </c:pt>
                <c:pt idx="2">
                  <c:v>1960</c:v>
                </c:pt>
                <c:pt idx="3">
                  <c:v>1961</c:v>
                </c:pt>
                <c:pt idx="4">
                  <c:v>1962</c:v>
                </c:pt>
                <c:pt idx="5">
                  <c:v>1963</c:v>
                </c:pt>
                <c:pt idx="6">
                  <c:v>1964</c:v>
                </c:pt>
                <c:pt idx="7">
                  <c:v>1965</c:v>
                </c:pt>
                <c:pt idx="8">
                  <c:v>1966</c:v>
                </c:pt>
                <c:pt idx="9">
                  <c:v>1967</c:v>
                </c:pt>
                <c:pt idx="10">
                  <c:v>1968</c:v>
                </c:pt>
                <c:pt idx="11">
                  <c:v>1969</c:v>
                </c:pt>
                <c:pt idx="12">
                  <c:v>1970</c:v>
                </c:pt>
                <c:pt idx="13">
                  <c:v>1971</c:v>
                </c:pt>
                <c:pt idx="14">
                  <c:v>1972</c:v>
                </c:pt>
                <c:pt idx="15">
                  <c:v>1973</c:v>
                </c:pt>
                <c:pt idx="16">
                  <c:v>1974</c:v>
                </c:pt>
                <c:pt idx="17">
                  <c:v>1975</c:v>
                </c:pt>
                <c:pt idx="18">
                  <c:v>1976</c:v>
                </c:pt>
                <c:pt idx="19">
                  <c:v>1977</c:v>
                </c:pt>
                <c:pt idx="20">
                  <c:v>1978</c:v>
                </c:pt>
                <c:pt idx="21">
                  <c:v>1979</c:v>
                </c:pt>
                <c:pt idx="22">
                  <c:v>1980</c:v>
                </c:pt>
                <c:pt idx="23">
                  <c:v>1981</c:v>
                </c:pt>
                <c:pt idx="24">
                  <c:v>1982</c:v>
                </c:pt>
                <c:pt idx="25">
                  <c:v>1983</c:v>
                </c:pt>
                <c:pt idx="26">
                  <c:v>1984</c:v>
                </c:pt>
                <c:pt idx="27">
                  <c:v>1985</c:v>
                </c:pt>
                <c:pt idx="28">
                  <c:v>1986</c:v>
                </c:pt>
                <c:pt idx="29">
                  <c:v>1987</c:v>
                </c:pt>
                <c:pt idx="30">
                  <c:v>1988</c:v>
                </c:pt>
                <c:pt idx="31">
                  <c:v>1989</c:v>
                </c:pt>
                <c:pt idx="32">
                  <c:v>1990</c:v>
                </c:pt>
                <c:pt idx="33">
                  <c:v>1991</c:v>
                </c:pt>
                <c:pt idx="34">
                  <c:v>1992</c:v>
                </c:pt>
                <c:pt idx="35">
                  <c:v>1993</c:v>
                </c:pt>
                <c:pt idx="36">
                  <c:v>1994</c:v>
                </c:pt>
                <c:pt idx="37">
                  <c:v>1995</c:v>
                </c:pt>
                <c:pt idx="38">
                  <c:v>1996</c:v>
                </c:pt>
                <c:pt idx="39">
                  <c:v>1997</c:v>
                </c:pt>
                <c:pt idx="40">
                  <c:v>1998</c:v>
                </c:pt>
                <c:pt idx="41">
                  <c:v>1999</c:v>
                </c:pt>
                <c:pt idx="42">
                  <c:v>2000</c:v>
                </c:pt>
                <c:pt idx="43">
                  <c:v>2001</c:v>
                </c:pt>
                <c:pt idx="44">
                  <c:v>2002</c:v>
                </c:pt>
                <c:pt idx="45">
                  <c:v>2003</c:v>
                </c:pt>
                <c:pt idx="46">
                  <c:v>2004</c:v>
                </c:pt>
                <c:pt idx="47">
                  <c:v>2005</c:v>
                </c:pt>
                <c:pt idx="48">
                  <c:v>2006</c:v>
                </c:pt>
                <c:pt idx="49">
                  <c:v>2007</c:v>
                </c:pt>
                <c:pt idx="50">
                  <c:v>2008</c:v>
                </c:pt>
                <c:pt idx="51">
                  <c:v>2009</c:v>
                </c:pt>
                <c:pt idx="52">
                  <c:v>2010</c:v>
                </c:pt>
                <c:pt idx="53" formatCode="@">
                  <c:v>2011</c:v>
                </c:pt>
                <c:pt idx="54">
                  <c:v>2012</c:v>
                </c:pt>
                <c:pt idx="55">
                  <c:v>2013</c:v>
                </c:pt>
                <c:pt idx="56">
                  <c:v>2014</c:v>
                </c:pt>
                <c:pt idx="57">
                  <c:v>2015</c:v>
                </c:pt>
                <c:pt idx="58">
                  <c:v>2016</c:v>
                </c:pt>
                <c:pt idx="59">
                  <c:v>2017</c:v>
                </c:pt>
                <c:pt idx="60">
                  <c:v>2018</c:v>
                </c:pt>
              </c:numCache>
            </c:numRef>
          </c:cat>
          <c:val>
            <c:numRef>
              <c:f>Sheet1!$D$2:$D$62</c:f>
              <c:numCache>
                <c:formatCode>0.0_ </c:formatCode>
                <c:ptCount val="61"/>
                <c:pt idx="0">
                  <c:v>8.3337835930999997</c:v>
                </c:pt>
                <c:pt idx="1">
                  <c:v>8.4321258832999995</c:v>
                </c:pt>
                <c:pt idx="2">
                  <c:v>8.4477062987</c:v>
                </c:pt>
                <c:pt idx="3">
                  <c:v>8.7931600673000005</c:v>
                </c:pt>
                <c:pt idx="4">
                  <c:v>8.6796755707000006</c:v>
                </c:pt>
                <c:pt idx="5">
                  <c:v>8.7297068426000006</c:v>
                </c:pt>
                <c:pt idx="6">
                  <c:v>8.8513706908999996</c:v>
                </c:pt>
                <c:pt idx="7">
                  <c:v>9.4120265809999992</c:v>
                </c:pt>
                <c:pt idx="8">
                  <c:v>9.6725976982000006</c:v>
                </c:pt>
                <c:pt idx="9">
                  <c:v>9.9070875276999999</c:v>
                </c:pt>
                <c:pt idx="10">
                  <c:v>10.284750946000001</c:v>
                </c:pt>
                <c:pt idx="11">
                  <c:v>10.610284403</c:v>
                </c:pt>
                <c:pt idx="12">
                  <c:v>10.332133031</c:v>
                </c:pt>
                <c:pt idx="13">
                  <c:v>10.859642042999999</c:v>
                </c:pt>
                <c:pt idx="14">
                  <c:v>10.880628856</c:v>
                </c:pt>
                <c:pt idx="15">
                  <c:v>11.509899919</c:v>
                </c:pt>
                <c:pt idx="16">
                  <c:v>11.81130456</c:v>
                </c:pt>
                <c:pt idx="17">
                  <c:v>11.681619617999999</c:v>
                </c:pt>
                <c:pt idx="18">
                  <c:v>11.848983681</c:v>
                </c:pt>
                <c:pt idx="19">
                  <c:v>11.83917284</c:v>
                </c:pt>
                <c:pt idx="20">
                  <c:v>12.419883625000001</c:v>
                </c:pt>
                <c:pt idx="21">
                  <c:v>12.348847975</c:v>
                </c:pt>
                <c:pt idx="22">
                  <c:v>12.322902251</c:v>
                </c:pt>
                <c:pt idx="23">
                  <c:v>12.827300344999999</c:v>
                </c:pt>
                <c:pt idx="24">
                  <c:v>12.79318121</c:v>
                </c:pt>
                <c:pt idx="25">
                  <c:v>13.018269418999999</c:v>
                </c:pt>
                <c:pt idx="26">
                  <c:v>13.183390642000001</c:v>
                </c:pt>
                <c:pt idx="27">
                  <c:v>13.150703142999999</c:v>
                </c:pt>
                <c:pt idx="28">
                  <c:v>13.239252205</c:v>
                </c:pt>
                <c:pt idx="29">
                  <c:v>13.163921839</c:v>
                </c:pt>
                <c:pt idx="30">
                  <c:v>13.682024709</c:v>
                </c:pt>
                <c:pt idx="31">
                  <c:v>13.936188958000001</c:v>
                </c:pt>
                <c:pt idx="32">
                  <c:v>13.902658473000001</c:v>
                </c:pt>
                <c:pt idx="33">
                  <c:v>13.992423326999999</c:v>
                </c:pt>
                <c:pt idx="34">
                  <c:v>14.206569192</c:v>
                </c:pt>
                <c:pt idx="35">
                  <c:v>14.007388710000001</c:v>
                </c:pt>
                <c:pt idx="36">
                  <c:v>13.954105365</c:v>
                </c:pt>
                <c:pt idx="37">
                  <c:v>14.142926083527676</c:v>
                </c:pt>
                <c:pt idx="38">
                  <c:v>14.202032431835278</c:v>
                </c:pt>
                <c:pt idx="39">
                  <c:v>14.049129754138068</c:v>
                </c:pt>
                <c:pt idx="40">
                  <c:v>13.918885565266496</c:v>
                </c:pt>
                <c:pt idx="41">
                  <c:v>13.92504102001458</c:v>
                </c:pt>
                <c:pt idx="42">
                  <c:v>13.614607394949093</c:v>
                </c:pt>
                <c:pt idx="43">
                  <c:v>13.559061774983986</c:v>
                </c:pt>
                <c:pt idx="44">
                  <c:v>13.364894013500942</c:v>
                </c:pt>
                <c:pt idx="45">
                  <c:v>13.52820846838266</c:v>
                </c:pt>
                <c:pt idx="46">
                  <c:v>13.400942957398234</c:v>
                </c:pt>
                <c:pt idx="47">
                  <c:v>13.155847007061805</c:v>
                </c:pt>
                <c:pt idx="48">
                  <c:v>12.651259509295333</c:v>
                </c:pt>
                <c:pt idx="49">
                  <c:v>12.571103316846017</c:v>
                </c:pt>
                <c:pt idx="50">
                  <c:v>12.319413891475408</c:v>
                </c:pt>
                <c:pt idx="51">
                  <c:v>12.057360009168299</c:v>
                </c:pt>
                <c:pt idx="52">
                  <c:v>12.100346074376569</c:v>
                </c:pt>
                <c:pt idx="53" formatCode="0.0_);[Red]\(0.0\)">
                  <c:v>12.0779962685853</c:v>
                </c:pt>
                <c:pt idx="54" formatCode="0.0">
                  <c:v>12.318998255847488</c:v>
                </c:pt>
                <c:pt idx="55" formatCode="0.0_);[Red]\(0.0\)">
                  <c:v>12.194735665806819</c:v>
                </c:pt>
                <c:pt idx="56" formatCode="0.0_);[Red]\(0.0\)">
                  <c:v>12.233884507945291</c:v>
                </c:pt>
                <c:pt idx="57" formatCode="0.0_);[Red]\(0.0\)">
                  <c:v>12.122426819787343</c:v>
                </c:pt>
                <c:pt idx="58" formatCode="0.0_);[Red]\(0.0\)">
                  <c:v>12.029294511113342</c:v>
                </c:pt>
                <c:pt idx="59" formatCode="0.0_);[Red]\(0.0\)">
                  <c:v>11.831408475008184</c:v>
                </c:pt>
                <c:pt idx="60" formatCode="0.0_);[Red]\(0.0\)">
                  <c:v>11.7392808738409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4EA-41B3-8532-411722C3D2D3}"/>
            </c:ext>
          </c:extLst>
        </c:ser>
        <c:ser>
          <c:idx val="3"/>
          <c:order val="2"/>
          <c:tx>
            <c:strRef>
              <c:f>Sheet1!$E$1</c:f>
              <c:strCache>
                <c:ptCount val="1"/>
                <c:pt idx="0">
                  <c:v>肝臓</c:v>
                </c:pt>
              </c:strCache>
            </c:strRef>
          </c:tx>
          <c:spPr>
            <a:ln w="38100" cap="rnd">
              <a:solidFill>
                <a:schemeClr val="accent4"/>
              </a:solidFill>
              <a:prstDash val="sysDot"/>
              <a:round/>
            </a:ln>
            <a:effectLst/>
          </c:spPr>
          <c:marker>
            <c:symbol val="none"/>
          </c:marker>
          <c:cat>
            <c:numRef>
              <c:f>Sheet1!$A$2:$A$62</c:f>
              <c:numCache>
                <c:formatCode>General</c:formatCode>
                <c:ptCount val="61"/>
                <c:pt idx="0">
                  <c:v>1958</c:v>
                </c:pt>
                <c:pt idx="1">
                  <c:v>1959</c:v>
                </c:pt>
                <c:pt idx="2">
                  <c:v>1960</c:v>
                </c:pt>
                <c:pt idx="3">
                  <c:v>1961</c:v>
                </c:pt>
                <c:pt idx="4">
                  <c:v>1962</c:v>
                </c:pt>
                <c:pt idx="5">
                  <c:v>1963</c:v>
                </c:pt>
                <c:pt idx="6">
                  <c:v>1964</c:v>
                </c:pt>
                <c:pt idx="7">
                  <c:v>1965</c:v>
                </c:pt>
                <c:pt idx="8">
                  <c:v>1966</c:v>
                </c:pt>
                <c:pt idx="9">
                  <c:v>1967</c:v>
                </c:pt>
                <c:pt idx="10">
                  <c:v>1968</c:v>
                </c:pt>
                <c:pt idx="11">
                  <c:v>1969</c:v>
                </c:pt>
                <c:pt idx="12">
                  <c:v>1970</c:v>
                </c:pt>
                <c:pt idx="13">
                  <c:v>1971</c:v>
                </c:pt>
                <c:pt idx="14">
                  <c:v>1972</c:v>
                </c:pt>
                <c:pt idx="15">
                  <c:v>1973</c:v>
                </c:pt>
                <c:pt idx="16">
                  <c:v>1974</c:v>
                </c:pt>
                <c:pt idx="17">
                  <c:v>1975</c:v>
                </c:pt>
                <c:pt idx="18">
                  <c:v>1976</c:v>
                </c:pt>
                <c:pt idx="19">
                  <c:v>1977</c:v>
                </c:pt>
                <c:pt idx="20">
                  <c:v>1978</c:v>
                </c:pt>
                <c:pt idx="21">
                  <c:v>1979</c:v>
                </c:pt>
                <c:pt idx="22">
                  <c:v>1980</c:v>
                </c:pt>
                <c:pt idx="23">
                  <c:v>1981</c:v>
                </c:pt>
                <c:pt idx="24">
                  <c:v>1982</c:v>
                </c:pt>
                <c:pt idx="25">
                  <c:v>1983</c:v>
                </c:pt>
                <c:pt idx="26">
                  <c:v>1984</c:v>
                </c:pt>
                <c:pt idx="27">
                  <c:v>1985</c:v>
                </c:pt>
                <c:pt idx="28">
                  <c:v>1986</c:v>
                </c:pt>
                <c:pt idx="29">
                  <c:v>1987</c:v>
                </c:pt>
                <c:pt idx="30">
                  <c:v>1988</c:v>
                </c:pt>
                <c:pt idx="31">
                  <c:v>1989</c:v>
                </c:pt>
                <c:pt idx="32">
                  <c:v>1990</c:v>
                </c:pt>
                <c:pt idx="33">
                  <c:v>1991</c:v>
                </c:pt>
                <c:pt idx="34">
                  <c:v>1992</c:v>
                </c:pt>
                <c:pt idx="35">
                  <c:v>1993</c:v>
                </c:pt>
                <c:pt idx="36">
                  <c:v>1994</c:v>
                </c:pt>
                <c:pt idx="37">
                  <c:v>1995</c:v>
                </c:pt>
                <c:pt idx="38">
                  <c:v>1996</c:v>
                </c:pt>
                <c:pt idx="39">
                  <c:v>1997</c:v>
                </c:pt>
                <c:pt idx="40">
                  <c:v>1998</c:v>
                </c:pt>
                <c:pt idx="41">
                  <c:v>1999</c:v>
                </c:pt>
                <c:pt idx="42">
                  <c:v>2000</c:v>
                </c:pt>
                <c:pt idx="43">
                  <c:v>2001</c:v>
                </c:pt>
                <c:pt idx="44">
                  <c:v>2002</c:v>
                </c:pt>
                <c:pt idx="45">
                  <c:v>2003</c:v>
                </c:pt>
                <c:pt idx="46">
                  <c:v>2004</c:v>
                </c:pt>
                <c:pt idx="47">
                  <c:v>2005</c:v>
                </c:pt>
                <c:pt idx="48">
                  <c:v>2006</c:v>
                </c:pt>
                <c:pt idx="49">
                  <c:v>2007</c:v>
                </c:pt>
                <c:pt idx="50">
                  <c:v>2008</c:v>
                </c:pt>
                <c:pt idx="51">
                  <c:v>2009</c:v>
                </c:pt>
                <c:pt idx="52">
                  <c:v>2010</c:v>
                </c:pt>
                <c:pt idx="53" formatCode="@">
                  <c:v>2011</c:v>
                </c:pt>
                <c:pt idx="54">
                  <c:v>2012</c:v>
                </c:pt>
                <c:pt idx="55">
                  <c:v>2013</c:v>
                </c:pt>
                <c:pt idx="56">
                  <c:v>2014</c:v>
                </c:pt>
                <c:pt idx="57">
                  <c:v>2015</c:v>
                </c:pt>
                <c:pt idx="58">
                  <c:v>2016</c:v>
                </c:pt>
                <c:pt idx="59">
                  <c:v>2017</c:v>
                </c:pt>
                <c:pt idx="60">
                  <c:v>2018</c:v>
                </c:pt>
              </c:numCache>
            </c:numRef>
          </c:cat>
          <c:val>
            <c:numRef>
              <c:f>Sheet1!$E$2:$E$62</c:f>
              <c:numCache>
                <c:formatCode>0.0_ </c:formatCode>
                <c:ptCount val="61"/>
                <c:pt idx="0">
                  <c:v>11.699521512</c:v>
                </c:pt>
                <c:pt idx="1">
                  <c:v>11.581122777999999</c:v>
                </c:pt>
                <c:pt idx="2">
                  <c:v>11.613924981</c:v>
                </c:pt>
                <c:pt idx="3">
                  <c:v>11.016871417000001</c:v>
                </c:pt>
                <c:pt idx="4">
                  <c:v>10.528444643</c:v>
                </c:pt>
                <c:pt idx="5">
                  <c:v>10.48274904</c:v>
                </c:pt>
                <c:pt idx="6">
                  <c:v>10.147237584000001</c:v>
                </c:pt>
                <c:pt idx="7">
                  <c:v>9.9233578679000001</c:v>
                </c:pt>
                <c:pt idx="8">
                  <c:v>9.8694370869999997</c:v>
                </c:pt>
                <c:pt idx="9">
                  <c:v>9.3250404027999991</c:v>
                </c:pt>
                <c:pt idx="10">
                  <c:v>9.2788498094000005</c:v>
                </c:pt>
                <c:pt idx="11">
                  <c:v>9.2687024267000009</c:v>
                </c:pt>
                <c:pt idx="12">
                  <c:v>8.9053899723000001</c:v>
                </c:pt>
                <c:pt idx="13">
                  <c:v>8.8640868931999997</c:v>
                </c:pt>
                <c:pt idx="14">
                  <c:v>8.5433198437000009</c:v>
                </c:pt>
                <c:pt idx="15">
                  <c:v>8.2028153271999997</c:v>
                </c:pt>
                <c:pt idx="16">
                  <c:v>7.9246826828000003</c:v>
                </c:pt>
                <c:pt idx="17">
                  <c:v>7.8317525274999999</c:v>
                </c:pt>
                <c:pt idx="18">
                  <c:v>7.9822121679000002</c:v>
                </c:pt>
                <c:pt idx="19">
                  <c:v>7.8534680132999997</c:v>
                </c:pt>
                <c:pt idx="20">
                  <c:v>8.0424919386999996</c:v>
                </c:pt>
                <c:pt idx="21">
                  <c:v>7.9456520660000001</c:v>
                </c:pt>
                <c:pt idx="22">
                  <c:v>7.7820314030000004</c:v>
                </c:pt>
                <c:pt idx="23">
                  <c:v>8.0187411502000003</c:v>
                </c:pt>
                <c:pt idx="24">
                  <c:v>7.8835606598999997</c:v>
                </c:pt>
                <c:pt idx="25">
                  <c:v>7.8910357101999997</c:v>
                </c:pt>
                <c:pt idx="26">
                  <c:v>7.9504663507000002</c:v>
                </c:pt>
                <c:pt idx="27">
                  <c:v>8.1406664584000001</c:v>
                </c:pt>
                <c:pt idx="28">
                  <c:v>7.9287792130000003</c:v>
                </c:pt>
                <c:pt idx="29">
                  <c:v>8.0278835887</c:v>
                </c:pt>
                <c:pt idx="30">
                  <c:v>8.1046324971000008</c:v>
                </c:pt>
                <c:pt idx="31">
                  <c:v>8.1166935663000004</c:v>
                </c:pt>
                <c:pt idx="32">
                  <c:v>8.3930443919000002</c:v>
                </c:pt>
                <c:pt idx="33">
                  <c:v>8.1748721301000007</c:v>
                </c:pt>
                <c:pt idx="34">
                  <c:v>8.3515351644999996</c:v>
                </c:pt>
                <c:pt idx="35">
                  <c:v>8.3664833366</c:v>
                </c:pt>
                <c:pt idx="36">
                  <c:v>8.3126178363999994</c:v>
                </c:pt>
                <c:pt idx="37">
                  <c:v>9.1461249441000003</c:v>
                </c:pt>
                <c:pt idx="38">
                  <c:v>9.1340066151000006</c:v>
                </c:pt>
                <c:pt idx="39">
                  <c:v>9.0361452877000001</c:v>
                </c:pt>
                <c:pt idx="40">
                  <c:v>9.0485174144999991</c:v>
                </c:pt>
                <c:pt idx="41">
                  <c:v>9.1446884403999995</c:v>
                </c:pt>
                <c:pt idx="42">
                  <c:v>8.8246309420000006</c:v>
                </c:pt>
                <c:pt idx="43">
                  <c:v>8.8171913037999996</c:v>
                </c:pt>
                <c:pt idx="44">
                  <c:v>8.5184606349000003</c:v>
                </c:pt>
                <c:pt idx="45">
                  <c:v>8.0592999267999996</c:v>
                </c:pt>
                <c:pt idx="46">
                  <c:v>8.0814211719000006</c:v>
                </c:pt>
                <c:pt idx="47">
                  <c:v>7.6881954031999999</c:v>
                </c:pt>
                <c:pt idx="48">
                  <c:v>7.4334151526000003</c:v>
                </c:pt>
                <c:pt idx="49">
                  <c:v>7.2719188700000004</c:v>
                </c:pt>
                <c:pt idx="50">
                  <c:v>6.9942401570000001</c:v>
                </c:pt>
                <c:pt idx="51">
                  <c:v>6.5706072816000001</c:v>
                </c:pt>
                <c:pt idx="52">
                  <c:v>6.3803729444000004</c:v>
                </c:pt>
                <c:pt idx="53" formatCode="0.0_);[Red]\(0.0\)">
                  <c:v>5.9866674689960382</c:v>
                </c:pt>
                <c:pt idx="54" formatCode="0.0">
                  <c:v>5.5562549207395504</c:v>
                </c:pt>
                <c:pt idx="55">
                  <c:v>5.2</c:v>
                </c:pt>
                <c:pt idx="56">
                  <c:v>5.0999999999999996</c:v>
                </c:pt>
                <c:pt idx="57">
                  <c:v>4.5999999999999996</c:v>
                </c:pt>
                <c:pt idx="58">
                  <c:v>4.5999999999999996</c:v>
                </c:pt>
                <c:pt idx="59">
                  <c:v>4</c:v>
                </c:pt>
                <c:pt idx="60" formatCode="0.0_);[Red]\(0.0\)">
                  <c:v>3.78683574923093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4EA-41B3-8532-411722C3D2D3}"/>
            </c:ext>
          </c:extLst>
        </c:ser>
        <c:ser>
          <c:idx val="6"/>
          <c:order val="3"/>
          <c:tx>
            <c:strRef>
              <c:f>Sheet1!$H$1</c:f>
              <c:strCache>
                <c:ptCount val="1"/>
                <c:pt idx="0">
                  <c:v>肺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Sheet1!$A$2:$A$62</c:f>
              <c:numCache>
                <c:formatCode>General</c:formatCode>
                <c:ptCount val="61"/>
                <c:pt idx="0">
                  <c:v>1958</c:v>
                </c:pt>
                <c:pt idx="1">
                  <c:v>1959</c:v>
                </c:pt>
                <c:pt idx="2">
                  <c:v>1960</c:v>
                </c:pt>
                <c:pt idx="3">
                  <c:v>1961</c:v>
                </c:pt>
                <c:pt idx="4">
                  <c:v>1962</c:v>
                </c:pt>
                <c:pt idx="5">
                  <c:v>1963</c:v>
                </c:pt>
                <c:pt idx="6">
                  <c:v>1964</c:v>
                </c:pt>
                <c:pt idx="7">
                  <c:v>1965</c:v>
                </c:pt>
                <c:pt idx="8">
                  <c:v>1966</c:v>
                </c:pt>
                <c:pt idx="9">
                  <c:v>1967</c:v>
                </c:pt>
                <c:pt idx="10">
                  <c:v>1968</c:v>
                </c:pt>
                <c:pt idx="11">
                  <c:v>1969</c:v>
                </c:pt>
                <c:pt idx="12">
                  <c:v>1970</c:v>
                </c:pt>
                <c:pt idx="13">
                  <c:v>1971</c:v>
                </c:pt>
                <c:pt idx="14">
                  <c:v>1972</c:v>
                </c:pt>
                <c:pt idx="15">
                  <c:v>1973</c:v>
                </c:pt>
                <c:pt idx="16">
                  <c:v>1974</c:v>
                </c:pt>
                <c:pt idx="17">
                  <c:v>1975</c:v>
                </c:pt>
                <c:pt idx="18">
                  <c:v>1976</c:v>
                </c:pt>
                <c:pt idx="19">
                  <c:v>1977</c:v>
                </c:pt>
                <c:pt idx="20">
                  <c:v>1978</c:v>
                </c:pt>
                <c:pt idx="21">
                  <c:v>1979</c:v>
                </c:pt>
                <c:pt idx="22">
                  <c:v>1980</c:v>
                </c:pt>
                <c:pt idx="23">
                  <c:v>1981</c:v>
                </c:pt>
                <c:pt idx="24">
                  <c:v>1982</c:v>
                </c:pt>
                <c:pt idx="25">
                  <c:v>1983</c:v>
                </c:pt>
                <c:pt idx="26">
                  <c:v>1984</c:v>
                </c:pt>
                <c:pt idx="27">
                  <c:v>1985</c:v>
                </c:pt>
                <c:pt idx="28">
                  <c:v>1986</c:v>
                </c:pt>
                <c:pt idx="29">
                  <c:v>1987</c:v>
                </c:pt>
                <c:pt idx="30">
                  <c:v>1988</c:v>
                </c:pt>
                <c:pt idx="31">
                  <c:v>1989</c:v>
                </c:pt>
                <c:pt idx="32">
                  <c:v>1990</c:v>
                </c:pt>
                <c:pt idx="33">
                  <c:v>1991</c:v>
                </c:pt>
                <c:pt idx="34">
                  <c:v>1992</c:v>
                </c:pt>
                <c:pt idx="35">
                  <c:v>1993</c:v>
                </c:pt>
                <c:pt idx="36">
                  <c:v>1994</c:v>
                </c:pt>
                <c:pt idx="37">
                  <c:v>1995</c:v>
                </c:pt>
                <c:pt idx="38">
                  <c:v>1996</c:v>
                </c:pt>
                <c:pt idx="39">
                  <c:v>1997</c:v>
                </c:pt>
                <c:pt idx="40">
                  <c:v>1998</c:v>
                </c:pt>
                <c:pt idx="41">
                  <c:v>1999</c:v>
                </c:pt>
                <c:pt idx="42">
                  <c:v>2000</c:v>
                </c:pt>
                <c:pt idx="43">
                  <c:v>2001</c:v>
                </c:pt>
                <c:pt idx="44">
                  <c:v>2002</c:v>
                </c:pt>
                <c:pt idx="45">
                  <c:v>2003</c:v>
                </c:pt>
                <c:pt idx="46">
                  <c:v>2004</c:v>
                </c:pt>
                <c:pt idx="47">
                  <c:v>2005</c:v>
                </c:pt>
                <c:pt idx="48">
                  <c:v>2006</c:v>
                </c:pt>
                <c:pt idx="49">
                  <c:v>2007</c:v>
                </c:pt>
                <c:pt idx="50">
                  <c:v>2008</c:v>
                </c:pt>
                <c:pt idx="51">
                  <c:v>2009</c:v>
                </c:pt>
                <c:pt idx="52">
                  <c:v>2010</c:v>
                </c:pt>
                <c:pt idx="53" formatCode="@">
                  <c:v>2011</c:v>
                </c:pt>
                <c:pt idx="54">
                  <c:v>2012</c:v>
                </c:pt>
                <c:pt idx="55">
                  <c:v>2013</c:v>
                </c:pt>
                <c:pt idx="56">
                  <c:v>2014</c:v>
                </c:pt>
                <c:pt idx="57">
                  <c:v>2015</c:v>
                </c:pt>
                <c:pt idx="58">
                  <c:v>2016</c:v>
                </c:pt>
                <c:pt idx="59">
                  <c:v>2017</c:v>
                </c:pt>
                <c:pt idx="60">
                  <c:v>2018</c:v>
                </c:pt>
              </c:numCache>
            </c:numRef>
          </c:cat>
          <c:val>
            <c:numRef>
              <c:f>Sheet1!$H$2:$H$62</c:f>
              <c:numCache>
                <c:formatCode>0.0_ </c:formatCode>
                <c:ptCount val="61"/>
                <c:pt idx="0">
                  <c:v>4.4005786475999997</c:v>
                </c:pt>
                <c:pt idx="1">
                  <c:v>4.5022522910999996</c:v>
                </c:pt>
                <c:pt idx="2">
                  <c:v>4.7925934727000001</c:v>
                </c:pt>
                <c:pt idx="3">
                  <c:v>5.3454990854000002</c:v>
                </c:pt>
                <c:pt idx="4">
                  <c:v>5.6074077720000002</c:v>
                </c:pt>
                <c:pt idx="5">
                  <c:v>5.7545504802999998</c:v>
                </c:pt>
                <c:pt idx="6">
                  <c:v>5.9690250050999998</c:v>
                </c:pt>
                <c:pt idx="7">
                  <c:v>6.4580051342000004</c:v>
                </c:pt>
                <c:pt idx="8">
                  <c:v>6.8037882637999996</c:v>
                </c:pt>
                <c:pt idx="9">
                  <c:v>6.7551421117999997</c:v>
                </c:pt>
                <c:pt idx="10">
                  <c:v>6.9326291252000001</c:v>
                </c:pt>
                <c:pt idx="11">
                  <c:v>7.3300880103999999</c:v>
                </c:pt>
                <c:pt idx="12">
                  <c:v>7.2721727269000001</c:v>
                </c:pt>
                <c:pt idx="13">
                  <c:v>7.2621975528</c:v>
                </c:pt>
                <c:pt idx="14">
                  <c:v>7.8979543195000002</c:v>
                </c:pt>
                <c:pt idx="15">
                  <c:v>7.9381481058999999</c:v>
                </c:pt>
                <c:pt idx="16">
                  <c:v>7.9881164211</c:v>
                </c:pt>
                <c:pt idx="17">
                  <c:v>8.3272224575999996</c:v>
                </c:pt>
                <c:pt idx="18">
                  <c:v>8.8540928800999996</c:v>
                </c:pt>
                <c:pt idx="19">
                  <c:v>9.0455708150999996</c:v>
                </c:pt>
                <c:pt idx="20">
                  <c:v>9.5366303049999992</c:v>
                </c:pt>
                <c:pt idx="21">
                  <c:v>9.5875433764999993</c:v>
                </c:pt>
                <c:pt idx="22">
                  <c:v>10.182435700999999</c:v>
                </c:pt>
                <c:pt idx="23">
                  <c:v>10.362207821</c:v>
                </c:pt>
                <c:pt idx="24">
                  <c:v>10.788991546</c:v>
                </c:pt>
                <c:pt idx="25">
                  <c:v>10.951697943999999</c:v>
                </c:pt>
                <c:pt idx="26">
                  <c:v>11.298504715</c:v>
                </c:pt>
                <c:pt idx="27">
                  <c:v>11.257950951</c:v>
                </c:pt>
                <c:pt idx="28">
                  <c:v>11.295124743000001</c:v>
                </c:pt>
                <c:pt idx="29">
                  <c:v>11.538722741999999</c:v>
                </c:pt>
                <c:pt idx="30">
                  <c:v>11.753341372</c:v>
                </c:pt>
                <c:pt idx="31">
                  <c:v>11.975382681999999</c:v>
                </c:pt>
                <c:pt idx="32">
                  <c:v>11.563548498999999</c:v>
                </c:pt>
                <c:pt idx="33">
                  <c:v>11.89934746</c:v>
                </c:pt>
                <c:pt idx="34">
                  <c:v>12.276206699999999</c:v>
                </c:pt>
                <c:pt idx="35">
                  <c:v>12.054824799</c:v>
                </c:pt>
                <c:pt idx="36">
                  <c:v>12.299653895000001</c:v>
                </c:pt>
                <c:pt idx="37">
                  <c:v>12.475605219</c:v>
                </c:pt>
                <c:pt idx="38">
                  <c:v>12.625948021999999</c:v>
                </c:pt>
                <c:pt idx="39">
                  <c:v>12.462108347999999</c:v>
                </c:pt>
                <c:pt idx="40">
                  <c:v>12.627914233</c:v>
                </c:pt>
                <c:pt idx="41">
                  <c:v>12.461383486000001</c:v>
                </c:pt>
                <c:pt idx="42">
                  <c:v>12.341243646000001</c:v>
                </c:pt>
                <c:pt idx="43">
                  <c:v>12.215755294999999</c:v>
                </c:pt>
                <c:pt idx="44">
                  <c:v>11.793023584</c:v>
                </c:pt>
                <c:pt idx="45">
                  <c:v>11.136333321</c:v>
                </c:pt>
                <c:pt idx="46">
                  <c:v>11.545129770000001</c:v>
                </c:pt>
                <c:pt idx="47">
                  <c:v>11.733144997</c:v>
                </c:pt>
                <c:pt idx="48">
                  <c:v>11.713350072000001</c:v>
                </c:pt>
                <c:pt idx="49">
                  <c:v>11.670059543000001</c:v>
                </c:pt>
                <c:pt idx="50">
                  <c:v>11.700434318999999</c:v>
                </c:pt>
                <c:pt idx="51">
                  <c:v>11.431400889000001</c:v>
                </c:pt>
                <c:pt idx="52">
                  <c:v>11.529140502000001</c:v>
                </c:pt>
                <c:pt idx="53" formatCode="0.0_);[Red]\(0.0\)">
                  <c:v>11.445367954233006</c:v>
                </c:pt>
                <c:pt idx="54" formatCode="0.0">
                  <c:v>11.411641478258126</c:v>
                </c:pt>
                <c:pt idx="55" formatCode="0.0_);[Red]\(0.0\)">
                  <c:v>11.405089849869819</c:v>
                </c:pt>
                <c:pt idx="56" formatCode="0.0_);[Red]\(0.0\)">
                  <c:v>11.354750390322961</c:v>
                </c:pt>
                <c:pt idx="57" formatCode="0.0_);[Red]\(0.0\)">
                  <c:v>11.138839179267459</c:v>
                </c:pt>
                <c:pt idx="58" formatCode="0.0_);[Red]\(0.0\)">
                  <c:v>10.958059183871208</c:v>
                </c:pt>
                <c:pt idx="59" formatCode="0.0_);[Red]\(0.0\)">
                  <c:v>10.332733898468993</c:v>
                </c:pt>
                <c:pt idx="60">
                  <c:v>10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54EA-41B3-8532-411722C3D2D3}"/>
            </c:ext>
          </c:extLst>
        </c:ser>
        <c:ser>
          <c:idx val="7"/>
          <c:order val="4"/>
          <c:tx>
            <c:strRef>
              <c:f>Sheet1!$I$1</c:f>
              <c:strCache>
                <c:ptCount val="1"/>
                <c:pt idx="0">
                  <c:v>乳房</c:v>
                </c:pt>
              </c:strCache>
            </c:strRef>
          </c:tx>
          <c:spPr>
            <a:ln w="381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Sheet1!$A$2:$A$62</c:f>
              <c:numCache>
                <c:formatCode>General</c:formatCode>
                <c:ptCount val="61"/>
                <c:pt idx="0">
                  <c:v>1958</c:v>
                </c:pt>
                <c:pt idx="1">
                  <c:v>1959</c:v>
                </c:pt>
                <c:pt idx="2">
                  <c:v>1960</c:v>
                </c:pt>
                <c:pt idx="3">
                  <c:v>1961</c:v>
                </c:pt>
                <c:pt idx="4">
                  <c:v>1962</c:v>
                </c:pt>
                <c:pt idx="5">
                  <c:v>1963</c:v>
                </c:pt>
                <c:pt idx="6">
                  <c:v>1964</c:v>
                </c:pt>
                <c:pt idx="7">
                  <c:v>1965</c:v>
                </c:pt>
                <c:pt idx="8">
                  <c:v>1966</c:v>
                </c:pt>
                <c:pt idx="9">
                  <c:v>1967</c:v>
                </c:pt>
                <c:pt idx="10">
                  <c:v>1968</c:v>
                </c:pt>
                <c:pt idx="11">
                  <c:v>1969</c:v>
                </c:pt>
                <c:pt idx="12">
                  <c:v>1970</c:v>
                </c:pt>
                <c:pt idx="13">
                  <c:v>1971</c:v>
                </c:pt>
                <c:pt idx="14">
                  <c:v>1972</c:v>
                </c:pt>
                <c:pt idx="15">
                  <c:v>1973</c:v>
                </c:pt>
                <c:pt idx="16">
                  <c:v>1974</c:v>
                </c:pt>
                <c:pt idx="17">
                  <c:v>1975</c:v>
                </c:pt>
                <c:pt idx="18">
                  <c:v>1976</c:v>
                </c:pt>
                <c:pt idx="19">
                  <c:v>1977</c:v>
                </c:pt>
                <c:pt idx="20">
                  <c:v>1978</c:v>
                </c:pt>
                <c:pt idx="21">
                  <c:v>1979</c:v>
                </c:pt>
                <c:pt idx="22">
                  <c:v>1980</c:v>
                </c:pt>
                <c:pt idx="23">
                  <c:v>1981</c:v>
                </c:pt>
                <c:pt idx="24">
                  <c:v>1982</c:v>
                </c:pt>
                <c:pt idx="25">
                  <c:v>1983</c:v>
                </c:pt>
                <c:pt idx="26">
                  <c:v>1984</c:v>
                </c:pt>
                <c:pt idx="27">
                  <c:v>1985</c:v>
                </c:pt>
                <c:pt idx="28">
                  <c:v>1986</c:v>
                </c:pt>
                <c:pt idx="29">
                  <c:v>1987</c:v>
                </c:pt>
                <c:pt idx="30">
                  <c:v>1988</c:v>
                </c:pt>
                <c:pt idx="31">
                  <c:v>1989</c:v>
                </c:pt>
                <c:pt idx="32">
                  <c:v>1990</c:v>
                </c:pt>
                <c:pt idx="33">
                  <c:v>1991</c:v>
                </c:pt>
                <c:pt idx="34">
                  <c:v>1992</c:v>
                </c:pt>
                <c:pt idx="35">
                  <c:v>1993</c:v>
                </c:pt>
                <c:pt idx="36">
                  <c:v>1994</c:v>
                </c:pt>
                <c:pt idx="37">
                  <c:v>1995</c:v>
                </c:pt>
                <c:pt idx="38">
                  <c:v>1996</c:v>
                </c:pt>
                <c:pt idx="39">
                  <c:v>1997</c:v>
                </c:pt>
                <c:pt idx="40">
                  <c:v>1998</c:v>
                </c:pt>
                <c:pt idx="41">
                  <c:v>1999</c:v>
                </c:pt>
                <c:pt idx="42">
                  <c:v>2000</c:v>
                </c:pt>
                <c:pt idx="43">
                  <c:v>2001</c:v>
                </c:pt>
                <c:pt idx="44">
                  <c:v>2002</c:v>
                </c:pt>
                <c:pt idx="45">
                  <c:v>2003</c:v>
                </c:pt>
                <c:pt idx="46">
                  <c:v>2004</c:v>
                </c:pt>
                <c:pt idx="47">
                  <c:v>2005</c:v>
                </c:pt>
                <c:pt idx="48">
                  <c:v>2006</c:v>
                </c:pt>
                <c:pt idx="49">
                  <c:v>2007</c:v>
                </c:pt>
                <c:pt idx="50">
                  <c:v>2008</c:v>
                </c:pt>
                <c:pt idx="51">
                  <c:v>2009</c:v>
                </c:pt>
                <c:pt idx="52">
                  <c:v>2010</c:v>
                </c:pt>
                <c:pt idx="53" formatCode="@">
                  <c:v>2011</c:v>
                </c:pt>
                <c:pt idx="54">
                  <c:v>2012</c:v>
                </c:pt>
                <c:pt idx="55">
                  <c:v>2013</c:v>
                </c:pt>
                <c:pt idx="56">
                  <c:v>2014</c:v>
                </c:pt>
                <c:pt idx="57">
                  <c:v>2015</c:v>
                </c:pt>
                <c:pt idx="58">
                  <c:v>2016</c:v>
                </c:pt>
                <c:pt idx="59">
                  <c:v>2017</c:v>
                </c:pt>
                <c:pt idx="60">
                  <c:v>2018</c:v>
                </c:pt>
              </c:numCache>
            </c:numRef>
          </c:cat>
          <c:val>
            <c:numRef>
              <c:f>Sheet1!$I$2:$I$62</c:f>
              <c:numCache>
                <c:formatCode>0.0_ </c:formatCode>
                <c:ptCount val="61"/>
                <c:pt idx="0">
                  <c:v>5.3046473011000002</c:v>
                </c:pt>
                <c:pt idx="1">
                  <c:v>5.0508705695999998</c:v>
                </c:pt>
                <c:pt idx="2">
                  <c:v>5.0618890729999997</c:v>
                </c:pt>
                <c:pt idx="3">
                  <c:v>5.0775626633000002</c:v>
                </c:pt>
                <c:pt idx="4">
                  <c:v>4.9296449081000002</c:v>
                </c:pt>
                <c:pt idx="5">
                  <c:v>5.1282056284999999</c:v>
                </c:pt>
                <c:pt idx="6">
                  <c:v>5.0103711422000003</c:v>
                </c:pt>
                <c:pt idx="7">
                  <c:v>5.160186231</c:v>
                </c:pt>
                <c:pt idx="8">
                  <c:v>5.3839961801999996</c:v>
                </c:pt>
                <c:pt idx="9">
                  <c:v>5.2905144679999996</c:v>
                </c:pt>
                <c:pt idx="10">
                  <c:v>5.4871870421000004</c:v>
                </c:pt>
                <c:pt idx="11">
                  <c:v>5.2699870147999999</c:v>
                </c:pt>
                <c:pt idx="12">
                  <c:v>5.7822649918</c:v>
                </c:pt>
                <c:pt idx="13">
                  <c:v>6.0431717026999996</c:v>
                </c:pt>
                <c:pt idx="14">
                  <c:v>6.0594285475999996</c:v>
                </c:pt>
                <c:pt idx="15">
                  <c:v>6.3354839599000004</c:v>
                </c:pt>
                <c:pt idx="16">
                  <c:v>6.3051801516000001</c:v>
                </c:pt>
                <c:pt idx="17">
                  <c:v>6.5112270797000003</c:v>
                </c:pt>
                <c:pt idx="18">
                  <c:v>6.5003554100000001</c:v>
                </c:pt>
                <c:pt idx="19">
                  <c:v>6.7625517328999996</c:v>
                </c:pt>
                <c:pt idx="20">
                  <c:v>6.9147278951000004</c:v>
                </c:pt>
                <c:pt idx="21">
                  <c:v>6.9587452882000003</c:v>
                </c:pt>
                <c:pt idx="22">
                  <c:v>7.2488638786999999</c:v>
                </c:pt>
                <c:pt idx="23">
                  <c:v>7.4605608065000002</c:v>
                </c:pt>
                <c:pt idx="24">
                  <c:v>7.1752427943999999</c:v>
                </c:pt>
                <c:pt idx="25">
                  <c:v>7.1743344770000004</c:v>
                </c:pt>
                <c:pt idx="26">
                  <c:v>7.6619746821000003</c:v>
                </c:pt>
                <c:pt idx="27">
                  <c:v>7.6442769569999998</c:v>
                </c:pt>
                <c:pt idx="28">
                  <c:v>7.7971260052</c:v>
                </c:pt>
                <c:pt idx="29">
                  <c:v>7.7543432779000003</c:v>
                </c:pt>
                <c:pt idx="30">
                  <c:v>8.1455877263000005</c:v>
                </c:pt>
                <c:pt idx="31">
                  <c:v>8.1944207352999996</c:v>
                </c:pt>
                <c:pt idx="32">
                  <c:v>8.1913088430999998</c:v>
                </c:pt>
                <c:pt idx="33">
                  <c:v>8.6620019251000002</c:v>
                </c:pt>
                <c:pt idx="34">
                  <c:v>8.7059012681999999</c:v>
                </c:pt>
                <c:pt idx="35">
                  <c:v>8.9173345072999997</c:v>
                </c:pt>
                <c:pt idx="36">
                  <c:v>9.2661307979000007</c:v>
                </c:pt>
                <c:pt idx="37">
                  <c:v>9.8794335486999998</c:v>
                </c:pt>
                <c:pt idx="38">
                  <c:v>9.8556675010999992</c:v>
                </c:pt>
                <c:pt idx="39">
                  <c:v>10.351526524000001</c:v>
                </c:pt>
                <c:pt idx="40">
                  <c:v>10.414851658</c:v>
                </c:pt>
                <c:pt idx="41">
                  <c:v>10.493153451</c:v>
                </c:pt>
                <c:pt idx="42">
                  <c:v>10.697221235000001</c:v>
                </c:pt>
                <c:pt idx="43">
                  <c:v>11.140424544</c:v>
                </c:pt>
                <c:pt idx="44">
                  <c:v>10.789685821999999</c:v>
                </c:pt>
                <c:pt idx="45">
                  <c:v>10.898944912999999</c:v>
                </c:pt>
                <c:pt idx="46">
                  <c:v>11.410950784000001</c:v>
                </c:pt>
                <c:pt idx="47">
                  <c:v>11.383189573999999</c:v>
                </c:pt>
                <c:pt idx="48">
                  <c:v>11.695823351</c:v>
                </c:pt>
                <c:pt idx="49">
                  <c:v>11.601918435</c:v>
                </c:pt>
                <c:pt idx="50">
                  <c:v>11.858338979999999</c:v>
                </c:pt>
                <c:pt idx="51">
                  <c:v>11.763263001</c:v>
                </c:pt>
                <c:pt idx="52">
                  <c:v>11.918322857</c:v>
                </c:pt>
                <c:pt idx="53" formatCode="0.0_);[Red]\(0.0\)">
                  <c:v>12.054760471927684</c:v>
                </c:pt>
                <c:pt idx="54" formatCode="0.0">
                  <c:v>11.482568683827617</c:v>
                </c:pt>
                <c:pt idx="55" formatCode="0.0_);[Red]\(0.0\)">
                  <c:v>12.016230934404133</c:v>
                </c:pt>
                <c:pt idx="56" formatCode="0.0_);[Red]\(0.0\)">
                  <c:v>11.840230594359161</c:v>
                </c:pt>
                <c:pt idx="57" formatCode="0.0_);[Red]\(0.0\)">
                  <c:v>11.955852443257113</c:v>
                </c:pt>
                <c:pt idx="58" formatCode="0.0_);[Red]\(0.0\)">
                  <c:v>12.193521549863124</c:v>
                </c:pt>
                <c:pt idx="59" formatCode="0.0_);[Red]\(0.0\)">
                  <c:v>12.15404580030309</c:v>
                </c:pt>
                <c:pt idx="60">
                  <c:v>12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AEA-496B-B71B-2115FECF8DBF}"/>
            </c:ext>
          </c:extLst>
        </c:ser>
        <c:ser>
          <c:idx val="8"/>
          <c:order val="5"/>
          <c:tx>
            <c:strRef>
              <c:f>Sheet1!$J$1</c:f>
              <c:strCache>
                <c:ptCount val="1"/>
                <c:pt idx="0">
                  <c:v>子宮</c:v>
                </c:pt>
              </c:strCache>
            </c:strRef>
          </c:tx>
          <c:spPr>
            <a:ln w="19050">
              <a:solidFill>
                <a:schemeClr val="tx1"/>
              </a:solidFill>
              <a:prstDash val="sysDash"/>
            </a:ln>
          </c:spPr>
          <c:marker>
            <c:symbol val="none"/>
          </c:marker>
          <c:cat>
            <c:numRef>
              <c:f>Sheet1!$A$2:$A$62</c:f>
              <c:numCache>
                <c:formatCode>General</c:formatCode>
                <c:ptCount val="61"/>
                <c:pt idx="0">
                  <c:v>1958</c:v>
                </c:pt>
                <c:pt idx="1">
                  <c:v>1959</c:v>
                </c:pt>
                <c:pt idx="2">
                  <c:v>1960</c:v>
                </c:pt>
                <c:pt idx="3">
                  <c:v>1961</c:v>
                </c:pt>
                <c:pt idx="4">
                  <c:v>1962</c:v>
                </c:pt>
                <c:pt idx="5">
                  <c:v>1963</c:v>
                </c:pt>
                <c:pt idx="6">
                  <c:v>1964</c:v>
                </c:pt>
                <c:pt idx="7">
                  <c:v>1965</c:v>
                </c:pt>
                <c:pt idx="8">
                  <c:v>1966</c:v>
                </c:pt>
                <c:pt idx="9">
                  <c:v>1967</c:v>
                </c:pt>
                <c:pt idx="10">
                  <c:v>1968</c:v>
                </c:pt>
                <c:pt idx="11">
                  <c:v>1969</c:v>
                </c:pt>
                <c:pt idx="12">
                  <c:v>1970</c:v>
                </c:pt>
                <c:pt idx="13">
                  <c:v>1971</c:v>
                </c:pt>
                <c:pt idx="14">
                  <c:v>1972</c:v>
                </c:pt>
                <c:pt idx="15">
                  <c:v>1973</c:v>
                </c:pt>
                <c:pt idx="16">
                  <c:v>1974</c:v>
                </c:pt>
                <c:pt idx="17">
                  <c:v>1975</c:v>
                </c:pt>
                <c:pt idx="18">
                  <c:v>1976</c:v>
                </c:pt>
                <c:pt idx="19">
                  <c:v>1977</c:v>
                </c:pt>
                <c:pt idx="20">
                  <c:v>1978</c:v>
                </c:pt>
                <c:pt idx="21">
                  <c:v>1979</c:v>
                </c:pt>
                <c:pt idx="22">
                  <c:v>1980</c:v>
                </c:pt>
                <c:pt idx="23">
                  <c:v>1981</c:v>
                </c:pt>
                <c:pt idx="24">
                  <c:v>1982</c:v>
                </c:pt>
                <c:pt idx="25">
                  <c:v>1983</c:v>
                </c:pt>
                <c:pt idx="26">
                  <c:v>1984</c:v>
                </c:pt>
                <c:pt idx="27">
                  <c:v>1985</c:v>
                </c:pt>
                <c:pt idx="28">
                  <c:v>1986</c:v>
                </c:pt>
                <c:pt idx="29">
                  <c:v>1987</c:v>
                </c:pt>
                <c:pt idx="30">
                  <c:v>1988</c:v>
                </c:pt>
                <c:pt idx="31">
                  <c:v>1989</c:v>
                </c:pt>
                <c:pt idx="32">
                  <c:v>1990</c:v>
                </c:pt>
                <c:pt idx="33">
                  <c:v>1991</c:v>
                </c:pt>
                <c:pt idx="34">
                  <c:v>1992</c:v>
                </c:pt>
                <c:pt idx="35">
                  <c:v>1993</c:v>
                </c:pt>
                <c:pt idx="36">
                  <c:v>1994</c:v>
                </c:pt>
                <c:pt idx="37">
                  <c:v>1995</c:v>
                </c:pt>
                <c:pt idx="38">
                  <c:v>1996</c:v>
                </c:pt>
                <c:pt idx="39">
                  <c:v>1997</c:v>
                </c:pt>
                <c:pt idx="40">
                  <c:v>1998</c:v>
                </c:pt>
                <c:pt idx="41">
                  <c:v>1999</c:v>
                </c:pt>
                <c:pt idx="42">
                  <c:v>2000</c:v>
                </c:pt>
                <c:pt idx="43">
                  <c:v>2001</c:v>
                </c:pt>
                <c:pt idx="44">
                  <c:v>2002</c:v>
                </c:pt>
                <c:pt idx="45">
                  <c:v>2003</c:v>
                </c:pt>
                <c:pt idx="46">
                  <c:v>2004</c:v>
                </c:pt>
                <c:pt idx="47">
                  <c:v>2005</c:v>
                </c:pt>
                <c:pt idx="48">
                  <c:v>2006</c:v>
                </c:pt>
                <c:pt idx="49">
                  <c:v>2007</c:v>
                </c:pt>
                <c:pt idx="50">
                  <c:v>2008</c:v>
                </c:pt>
                <c:pt idx="51">
                  <c:v>2009</c:v>
                </c:pt>
                <c:pt idx="52">
                  <c:v>2010</c:v>
                </c:pt>
                <c:pt idx="53" formatCode="@">
                  <c:v>2011</c:v>
                </c:pt>
                <c:pt idx="54">
                  <c:v>2012</c:v>
                </c:pt>
                <c:pt idx="55">
                  <c:v>2013</c:v>
                </c:pt>
                <c:pt idx="56">
                  <c:v>2014</c:v>
                </c:pt>
                <c:pt idx="57">
                  <c:v>2015</c:v>
                </c:pt>
                <c:pt idx="58">
                  <c:v>2016</c:v>
                </c:pt>
                <c:pt idx="59">
                  <c:v>2017</c:v>
                </c:pt>
                <c:pt idx="60">
                  <c:v>2018</c:v>
                </c:pt>
              </c:numCache>
            </c:numRef>
          </c:cat>
          <c:val>
            <c:numRef>
              <c:f>Sheet1!$J$2:$J$62</c:f>
              <c:numCache>
                <c:formatCode>0.0_ </c:formatCode>
                <c:ptCount val="61"/>
                <c:pt idx="0">
                  <c:v>22.414002697000001</c:v>
                </c:pt>
                <c:pt idx="1">
                  <c:v>21.816350304</c:v>
                </c:pt>
                <c:pt idx="2">
                  <c:v>21.282835488</c:v>
                </c:pt>
                <c:pt idx="3">
                  <c:v>20.434267694999999</c:v>
                </c:pt>
                <c:pt idx="4">
                  <c:v>19.865534742000001</c:v>
                </c:pt>
                <c:pt idx="5">
                  <c:v>19.445936389</c:v>
                </c:pt>
                <c:pt idx="6">
                  <c:v>18.434151946</c:v>
                </c:pt>
                <c:pt idx="7">
                  <c:v>18.004141782000001</c:v>
                </c:pt>
                <c:pt idx="8">
                  <c:v>17.457326778999999</c:v>
                </c:pt>
                <c:pt idx="9">
                  <c:v>17.076510621000001</c:v>
                </c:pt>
                <c:pt idx="10">
                  <c:v>16.484715373</c:v>
                </c:pt>
                <c:pt idx="11">
                  <c:v>15.912604427</c:v>
                </c:pt>
                <c:pt idx="12">
                  <c:v>15.108506024</c:v>
                </c:pt>
                <c:pt idx="13">
                  <c:v>14.269582771</c:v>
                </c:pt>
                <c:pt idx="14">
                  <c:v>14.204073062999999</c:v>
                </c:pt>
                <c:pt idx="15">
                  <c:v>13.103407395</c:v>
                </c:pt>
                <c:pt idx="16">
                  <c:v>12.954004767000001</c:v>
                </c:pt>
                <c:pt idx="17">
                  <c:v>12.351067390000001</c:v>
                </c:pt>
                <c:pt idx="18">
                  <c:v>11.641333738</c:v>
                </c:pt>
                <c:pt idx="19">
                  <c:v>10.903125706000001</c:v>
                </c:pt>
                <c:pt idx="20">
                  <c:v>10.609093472</c:v>
                </c:pt>
                <c:pt idx="21">
                  <c:v>10.172411477000001</c:v>
                </c:pt>
                <c:pt idx="22">
                  <c:v>9.5459974061999997</c:v>
                </c:pt>
                <c:pt idx="23">
                  <c:v>9.0553807029000009</c:v>
                </c:pt>
                <c:pt idx="24">
                  <c:v>8.4661664026000008</c:v>
                </c:pt>
                <c:pt idx="25">
                  <c:v>8.1280945252999999</c:v>
                </c:pt>
                <c:pt idx="26">
                  <c:v>7.6422417196000003</c:v>
                </c:pt>
                <c:pt idx="27">
                  <c:v>7.3262188357999998</c:v>
                </c:pt>
                <c:pt idx="28">
                  <c:v>6.8349912484999997</c:v>
                </c:pt>
                <c:pt idx="29">
                  <c:v>6.4320067200000004</c:v>
                </c:pt>
                <c:pt idx="30">
                  <c:v>6.3612521368000001</c:v>
                </c:pt>
                <c:pt idx="31">
                  <c:v>6.0622482583000004</c:v>
                </c:pt>
                <c:pt idx="32">
                  <c:v>5.8416088800999999</c:v>
                </c:pt>
                <c:pt idx="33">
                  <c:v>5.7132462420000003</c:v>
                </c:pt>
                <c:pt idx="34">
                  <c:v>5.6283674023000003</c:v>
                </c:pt>
                <c:pt idx="35">
                  <c:v>5.2083196264999998</c:v>
                </c:pt>
                <c:pt idx="36">
                  <c:v>5.2470810423999996</c:v>
                </c:pt>
                <c:pt idx="37">
                  <c:v>5.4110020806000003</c:v>
                </c:pt>
                <c:pt idx="38">
                  <c:v>5.4271755035</c:v>
                </c:pt>
                <c:pt idx="39">
                  <c:v>5.3053454058999998</c:v>
                </c:pt>
                <c:pt idx="40">
                  <c:v>5.2372964169999996</c:v>
                </c:pt>
                <c:pt idx="41">
                  <c:v>5.2469635382000002</c:v>
                </c:pt>
                <c:pt idx="42">
                  <c:v>5.3097203749000004</c:v>
                </c:pt>
                <c:pt idx="43">
                  <c:v>5.1750473773000003</c:v>
                </c:pt>
                <c:pt idx="44">
                  <c:v>5.2183403094000003</c:v>
                </c:pt>
                <c:pt idx="45">
                  <c:v>5.0922403325000003</c:v>
                </c:pt>
                <c:pt idx="46">
                  <c:v>5.2409859735</c:v>
                </c:pt>
                <c:pt idx="47">
                  <c:v>5.1195226381000003</c:v>
                </c:pt>
                <c:pt idx="48">
                  <c:v>5.1212618606999998</c:v>
                </c:pt>
                <c:pt idx="49">
                  <c:v>5.0899274005999997</c:v>
                </c:pt>
                <c:pt idx="50">
                  <c:v>5.2161053845999996</c:v>
                </c:pt>
                <c:pt idx="51">
                  <c:v>4.9963330490000004</c:v>
                </c:pt>
                <c:pt idx="52">
                  <c:v>5.2759591576</c:v>
                </c:pt>
                <c:pt idx="53" formatCode="0.0_);[Red]\(0.0\)">
                  <c:v>5.4373405945773658</c:v>
                </c:pt>
                <c:pt idx="54" formatCode="0.0">
                  <c:v>5.3706845356157675</c:v>
                </c:pt>
                <c:pt idx="55" formatCode="0.0_);[Red]\(0.0\)">
                  <c:v>5.2979146118405307</c:v>
                </c:pt>
                <c:pt idx="56" formatCode="0.0_);[Red]\(0.0\)">
                  <c:v>5.6771516579976495</c:v>
                </c:pt>
                <c:pt idx="57" formatCode="0.0_);[Red]\(0.0\)">
                  <c:v>5.6187205138641216</c:v>
                </c:pt>
                <c:pt idx="58" formatCode="0.0_);[Red]\(0.0\)">
                  <c:v>5.4697878151472583</c:v>
                </c:pt>
                <c:pt idx="59" formatCode="0.0_);[Red]\(0.0\)">
                  <c:v>5.6071138746783529</c:v>
                </c:pt>
                <c:pt idx="60">
                  <c:v>5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AEA-496B-B71B-2115FECF8D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03501376"/>
        <c:axId val="303504096"/>
      </c:lineChart>
      <c:catAx>
        <c:axId val="3035013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cap="none" spc="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03504096"/>
        <c:crosses val="autoZero"/>
        <c:auto val="1"/>
        <c:lblAlgn val="ctr"/>
        <c:lblOffset val="100"/>
        <c:tickLblSkip val="2"/>
        <c:noMultiLvlLbl val="0"/>
      </c:catAx>
      <c:valAx>
        <c:axId val="303504096"/>
        <c:scaling>
          <c:logBase val="10"/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numFmt formatCode="0.0_ 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03501376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1026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" y="0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099" name="Rectangle 1027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1543" y="0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100" name="Rectangle 1028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1" y="9430387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101" name="Rectangle 1029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1543" y="9430387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fld id="{F04146FC-D5C5-4BA4-8C1B-5F38138DDB21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41296642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17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2" y="1"/>
            <a:ext cx="2922350" cy="459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7817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45199" y="1"/>
            <a:ext cx="2922349" cy="459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554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69963" y="765175"/>
            <a:ext cx="4905375" cy="367982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7818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22849" y="4751660"/>
            <a:ext cx="4997963" cy="44456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17818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2" y="9427217"/>
            <a:ext cx="2922350" cy="5358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7818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45199" y="9427217"/>
            <a:ext cx="2922349" cy="5358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fld id="{F3A0F74B-D64D-415A-BCE6-EF678DD9050B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82790220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F3A0F74B-D64D-415A-BCE6-EF678DD9050B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1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677496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0113" y="2997200"/>
            <a:ext cx="7848600" cy="9032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76" name="Rectangle 4"/>
          <p:cNvSpPr>
            <a:spLocks noGrp="1" noChangeArrowheads="1"/>
          </p:cNvSpPr>
          <p:nvPr>
            <p:ph type="ctrTitle"/>
          </p:nvPr>
        </p:nvSpPr>
        <p:spPr>
          <a:xfrm>
            <a:off x="683568" y="1772816"/>
            <a:ext cx="7772400" cy="1470025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ja-JP" altLang="en-US" noProof="0"/>
              <a:t>マスター タイトルの書式設定</a:t>
            </a:r>
          </a:p>
        </p:txBody>
      </p:sp>
      <p:sp>
        <p:nvSpPr>
          <p:cNvPr id="3077" name="Rectangle 5"/>
          <p:cNvSpPr>
            <a:spLocks noGrp="1" noChangeArrowheads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FontTx/>
              <a:buNone/>
              <a:defRPr sz="2800"/>
            </a:lvl1pPr>
          </a:lstStyle>
          <a:p>
            <a:pPr lvl="0"/>
            <a:r>
              <a:rPr lang="ja-JP" altLang="en-US" noProof="0"/>
              <a:t>マスター サブタイトルの書式設定</a:t>
            </a:r>
          </a:p>
        </p:txBody>
      </p:sp>
      <p:sp>
        <p:nvSpPr>
          <p:cNvPr id="3078" name="Rectangle 6"/>
          <p:cNvSpPr>
            <a:spLocks noGrp="1" noChangeArrowheads="1"/>
          </p:cNvSpPr>
          <p:nvPr>
            <p:ph type="dt" sz="half" idx="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3079" name="Rectangle 7"/>
          <p:cNvSpPr>
            <a:spLocks noGrp="1" noChangeArrowheads="1"/>
          </p:cNvSpPr>
          <p:nvPr>
            <p:ph type="ftr" sz="quarter" idx="3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3080" name="Rectangle 8"/>
          <p:cNvSpPr>
            <a:spLocks noGrp="1" noChangeArrowheads="1"/>
          </p:cNvSpPr>
          <p:nvPr>
            <p:ph type="sldNum" sz="quarter" idx="4"/>
          </p:nvPr>
        </p:nvSpPr>
        <p:spPr/>
        <p:txBody>
          <a:bodyPr/>
          <a:lstStyle>
            <a:lvl1pPr>
              <a:defRPr/>
            </a:lvl1pPr>
          </a:lstStyle>
          <a:p>
            <a:fld id="{8630D260-68D9-45D3-9739-E526F76B7E3B}" type="slidenum">
              <a:rPr lang="en-US" altLang="ja-JP">
                <a:solidFill>
                  <a:prstClr val="black"/>
                </a:solidFill>
              </a:rPr>
              <a:pPr/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646607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44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44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4276896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タイトル、テキスト、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7818"/>
            <a:ext cx="8229600" cy="11398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sz="half" idx="1"/>
          </p:nvPr>
        </p:nvSpPr>
        <p:spPr>
          <a:xfrm>
            <a:off x="457203" y="1600206"/>
            <a:ext cx="4044462" cy="45307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2338" y="1600206"/>
            <a:ext cx="4044462" cy="45307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1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Rectangle 1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Rectangle 14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512C04E-7F54-4F85-815C-28C6CA88C1E5}" type="slidenum">
              <a:rPr lang="en-US" altLang="ja-JP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F41859F-2DFA-45B2-868E-D9234AD5B191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5805732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252918-2AF6-40BD-B5EF-AABFF6971CF9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7308440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2F6D45-AD93-4867-80AA-AF8CC88DBF28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36125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DBB7C49-BA37-4981-B42A-9A9C3EEDB9AB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6700959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6A7FF15-3EB3-4A4D-B86D-7F5536B77447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1311820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10A34F-2515-4907-BC41-31A9E2F48D09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7915672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9AF1B06-2876-4226-A55D-1BCD4424BE58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555945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126D4F-3EDC-4F67-81E1-7E3B730BC726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1923113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25C039E-5AB4-4307-9928-28393E968C8A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08870277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00893F-DCA0-4281-B3C3-6B2BB407F5FB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97074490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2178D07-A73C-426D-AD67-383107A28595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12535379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0E15D35-2CB8-463B-81F5-44A2FE416D67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88341273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chart" preserve="1">
  <p:cSld name="タイトルとグラフ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グラフ プレースホルダ 2"/>
          <p:cNvSpPr>
            <a:spLocks noGrp="1"/>
          </p:cNvSpPr>
          <p:nvPr>
            <p:ph type="chart" idx="1"/>
          </p:nvPr>
        </p:nvSpPr>
        <p:spPr>
          <a:xfrm>
            <a:off x="685800" y="1981200"/>
            <a:ext cx="7772400" cy="4114800"/>
          </a:xfrm>
        </p:spPr>
        <p:txBody>
          <a:bodyPr/>
          <a:lstStyle/>
          <a:p>
            <a:pPr lvl="0"/>
            <a:endParaRPr lang="ja-JP" altLang="en-US" noProof="0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7BA7417-152D-4A3E-83DF-64C91BA8FAF2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0237277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タイトルと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表プレースホルダ 2"/>
          <p:cNvSpPr>
            <a:spLocks noGrp="1"/>
          </p:cNvSpPr>
          <p:nvPr>
            <p:ph type="tbl" idx="1"/>
          </p:nvPr>
        </p:nvSpPr>
        <p:spPr>
          <a:xfrm>
            <a:off x="685800" y="1981200"/>
            <a:ext cx="7772400" cy="4114800"/>
          </a:xfrm>
        </p:spPr>
        <p:txBody>
          <a:bodyPr/>
          <a:lstStyle/>
          <a:p>
            <a:pPr lvl="0"/>
            <a:endParaRPr lang="ja-JP" altLang="en-US" noProof="0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D977C7-3B0D-4BD8-A2B7-C7FDC17ABF80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13127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6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FB67A0-E466-4A89-B796-1312CC8BDE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13623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27088" y="1773243"/>
            <a:ext cx="3852862" cy="4352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832350" y="1773243"/>
            <a:ext cx="3854450" cy="4352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7FABE6-EE91-4374-8988-8639AC3FF2BA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60904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426A84-590D-4994-AD3B-BF3EBB6C2AF1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88644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E63697-0A4E-4916-BEB4-6D0ABB3B2E5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35224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82F1FB-B130-4DC9-947D-26E8A4BB2D4C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51503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1" y="273056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36034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700CEC-AB21-4C70-A4C5-0E6288EFC26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21726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image" Target="../media/image2.jpeg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1.pn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slideLayout" Target="../slideLayouts/slideLayout25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Relationship Id="rId14" Type="http://schemas.openxmlformats.org/officeDocument/2006/relationships/theme" Target="../theme/theme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950" y="620716"/>
            <a:ext cx="754063" cy="5876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827088" y="1773242"/>
            <a:ext cx="7859712" cy="4352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+mn-lt"/>
                <a:ea typeface="+mn-ea"/>
                <a:cs typeface="+mn-cs"/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+mn-lt"/>
                <a:ea typeface="+mn-ea"/>
                <a:cs typeface="+mn-cs"/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+mn-lt"/>
                <a:ea typeface="+mn-ea"/>
                <a:cs typeface="+mn-cs"/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31" r:id="rId1"/>
    <p:sldLayoutId id="2147483932" r:id="rId2"/>
    <p:sldLayoutId id="2147483933" r:id="rId3"/>
    <p:sldLayoutId id="2147483934" r:id="rId4"/>
    <p:sldLayoutId id="2147483935" r:id="rId5"/>
    <p:sldLayoutId id="2147483936" r:id="rId6"/>
    <p:sldLayoutId id="2147483937" r:id="rId7"/>
    <p:sldLayoutId id="2147483938" r:id="rId8"/>
    <p:sldLayoutId id="2147483939" r:id="rId9"/>
    <p:sldLayoutId id="2147483940" r:id="rId10"/>
    <p:sldLayoutId id="2147483941" r:id="rId11"/>
    <p:sldLayoutId id="2147483942" r:id="rId12"/>
  </p:sldLayoutIdLst>
  <p:txStyles>
    <p:titleStyle>
      <a:lvl1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2pPr>
      <a:lvl3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3pPr>
      <a:lvl4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4pPr>
      <a:lvl5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8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4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ＭＳ Ｐゴシック" pitchFamily="50" charset="-128"/>
              </a:defRPr>
            </a:lvl1pPr>
          </a:lstStyle>
          <a:p>
            <a:pPr>
              <a:defRPr/>
            </a:pPr>
            <a:fld id="{77D792E0-73A5-4B2D-A6CD-9A2E2514D356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405223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6298" r:id="rId1"/>
    <p:sldLayoutId id="2147486299" r:id="rId2"/>
    <p:sldLayoutId id="2147486300" r:id="rId3"/>
    <p:sldLayoutId id="2147486301" r:id="rId4"/>
    <p:sldLayoutId id="2147486302" r:id="rId5"/>
    <p:sldLayoutId id="2147486303" r:id="rId6"/>
    <p:sldLayoutId id="2147486304" r:id="rId7"/>
    <p:sldLayoutId id="2147486305" r:id="rId8"/>
    <p:sldLayoutId id="2147486306" r:id="rId9"/>
    <p:sldLayoutId id="2147486307" r:id="rId10"/>
    <p:sldLayoutId id="2147486308" r:id="rId11"/>
    <p:sldLayoutId id="2147486309" r:id="rId12"/>
    <p:sldLayoutId id="2147486310" r:id="rId13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6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タイトル 8"/>
          <p:cNvSpPr>
            <a:spLocks noGrp="1"/>
          </p:cNvSpPr>
          <p:nvPr>
            <p:ph type="title"/>
          </p:nvPr>
        </p:nvSpPr>
        <p:spPr>
          <a:xfrm>
            <a:off x="264009" y="94707"/>
            <a:ext cx="8499165" cy="962901"/>
          </a:xfrm>
        </p:spPr>
        <p:txBody>
          <a:bodyPr/>
          <a:lstStyle/>
          <a:p>
            <a:pPr algn="l"/>
            <a:r>
              <a:rPr lang="en-US" altLang="ja-JP" sz="2000" dirty="0">
                <a:solidFill>
                  <a:srgbClr val="000000"/>
                </a:solidFill>
                <a:latin typeface="Arial"/>
              </a:rPr>
              <a:t>Supplemental Figure 2</a:t>
            </a:r>
            <a:br>
              <a:rPr lang="en-US" altLang="ja-JP" sz="2000" dirty="0">
                <a:solidFill>
                  <a:srgbClr val="000000"/>
                </a:solidFill>
                <a:latin typeface="Arial"/>
              </a:rPr>
            </a:br>
            <a:r>
              <a:rPr lang="en-US" altLang="ja-JP" sz="2000" dirty="0">
                <a:solidFill>
                  <a:srgbClr val="000000"/>
                </a:solidFill>
                <a:latin typeface="Arial"/>
              </a:rPr>
              <a:t>Annual trends in age-standardized mortality rate per 100,000 Japan 1985 model population for major cancer sites</a:t>
            </a:r>
          </a:p>
        </p:txBody>
      </p:sp>
      <p:graphicFrame>
        <p:nvGraphicFramePr>
          <p:cNvPr id="26" name="コンテンツ プレースホルダー 25"/>
          <p:cNvGraphicFramePr>
            <a:graphicFrameLocks noGrp="1"/>
          </p:cNvGraphicFramePr>
          <p:nvPr>
            <p:ph sz="half" idx="1"/>
            <p:extLst>
              <p:ext uri="{D42A27DB-BD31-4B8C-83A1-F6EECF244321}">
                <p14:modId xmlns:p14="http://schemas.microsoft.com/office/powerpoint/2010/main" val="33409778"/>
              </p:ext>
            </p:extLst>
          </p:nvPr>
        </p:nvGraphicFramePr>
        <p:xfrm>
          <a:off x="251520" y="1196752"/>
          <a:ext cx="4357600" cy="51125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7" name="コンテンツ プレースホルダー 25"/>
          <p:cNvGraphicFramePr>
            <a:graphicFrameLocks noGrp="1"/>
          </p:cNvGraphicFramePr>
          <p:nvPr>
            <p:ph sz="half" idx="4294967295"/>
            <p:extLst>
              <p:ext uri="{D42A27DB-BD31-4B8C-83A1-F6EECF244321}">
                <p14:modId xmlns:p14="http://schemas.microsoft.com/office/powerpoint/2010/main" val="795975191"/>
              </p:ext>
            </p:extLst>
          </p:nvPr>
        </p:nvGraphicFramePr>
        <p:xfrm>
          <a:off x="4609120" y="1196752"/>
          <a:ext cx="4283360" cy="51125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73A12F5-FF62-4810-B18E-BF37FC7D4E65}"/>
              </a:ext>
            </a:extLst>
          </p:cNvPr>
          <p:cNvSpPr txBox="1"/>
          <p:nvPr/>
        </p:nvSpPr>
        <p:spPr>
          <a:xfrm>
            <a:off x="904984" y="2086000"/>
            <a:ext cx="833883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Stomach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905B3AD-9F79-4435-A421-1A1F7B74FF0E}"/>
              </a:ext>
            </a:extLst>
          </p:cNvPr>
          <p:cNvSpPr txBox="1"/>
          <p:nvPr/>
        </p:nvSpPr>
        <p:spPr>
          <a:xfrm>
            <a:off x="3741691" y="2076645"/>
            <a:ext cx="562975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Lung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9D1621B-37B8-49A9-B6FF-31C69D1ED025}"/>
              </a:ext>
            </a:extLst>
          </p:cNvPr>
          <p:cNvSpPr txBox="1"/>
          <p:nvPr/>
        </p:nvSpPr>
        <p:spPr>
          <a:xfrm>
            <a:off x="904984" y="2883101"/>
            <a:ext cx="410369" cy="18466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lIns="0" tIns="0" rIns="0" bIns="0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Liver</a:t>
            </a:r>
            <a:r>
              <a:rPr kumimoji="1" lang="ja-JP" alt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 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33499A0-BF48-4A4C-8308-8B6DEAFA5982}"/>
              </a:ext>
            </a:extLst>
          </p:cNvPr>
          <p:cNvSpPr txBox="1"/>
          <p:nvPr/>
        </p:nvSpPr>
        <p:spPr>
          <a:xfrm>
            <a:off x="3169498" y="4217030"/>
            <a:ext cx="657231" cy="18466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lIns="0" tIns="0" rIns="0" bIns="0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Prostate 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5C90441B-902F-4FE4-B19A-88DD37FAC5E7}"/>
              </a:ext>
            </a:extLst>
          </p:cNvPr>
          <p:cNvSpPr txBox="1"/>
          <p:nvPr/>
        </p:nvSpPr>
        <p:spPr>
          <a:xfrm>
            <a:off x="2643713" y="3280926"/>
            <a:ext cx="854401" cy="18466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lIns="0" tIns="0" rIns="0" bIns="0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Colorectum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DB20DA3-5C3D-41AD-A2AF-9BDBBFAF29E4}"/>
              </a:ext>
            </a:extLst>
          </p:cNvPr>
          <p:cNvSpPr txBox="1"/>
          <p:nvPr/>
        </p:nvSpPr>
        <p:spPr>
          <a:xfrm>
            <a:off x="6217784" y="3252247"/>
            <a:ext cx="854401" cy="18466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lIns="0" tIns="0" rIns="0" bIns="0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Colorectum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18AE4AF-622A-4AE9-9A0A-E1C36637BC38}"/>
              </a:ext>
            </a:extLst>
          </p:cNvPr>
          <p:cNvSpPr txBox="1"/>
          <p:nvPr/>
        </p:nvSpPr>
        <p:spPr>
          <a:xfrm>
            <a:off x="5568567" y="1949351"/>
            <a:ext cx="649217" cy="1846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Stomach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0E590309-1779-4C2B-A871-AD22D2D6EA2B}"/>
              </a:ext>
            </a:extLst>
          </p:cNvPr>
          <p:cNvSpPr txBox="1"/>
          <p:nvPr/>
        </p:nvSpPr>
        <p:spPr>
          <a:xfrm>
            <a:off x="6750800" y="3753036"/>
            <a:ext cx="378309" cy="1846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Lung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3C9E35C6-B398-4BBD-9F52-78347847DC13}"/>
              </a:ext>
            </a:extLst>
          </p:cNvPr>
          <p:cNvSpPr txBox="1"/>
          <p:nvPr/>
        </p:nvSpPr>
        <p:spPr>
          <a:xfrm>
            <a:off x="6032289" y="4411407"/>
            <a:ext cx="519373" cy="1846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Breast 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2E9CEF5F-5719-42A0-B678-F47F2ED538A0}"/>
              </a:ext>
            </a:extLst>
          </p:cNvPr>
          <p:cNvSpPr txBox="1"/>
          <p:nvPr/>
        </p:nvSpPr>
        <p:spPr>
          <a:xfrm>
            <a:off x="5337694" y="2914363"/>
            <a:ext cx="615553" cy="1846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Uterus   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81A782E8-34B1-46D3-80F7-0B6174F7921E}"/>
              </a:ext>
            </a:extLst>
          </p:cNvPr>
          <p:cNvSpPr txBox="1"/>
          <p:nvPr/>
        </p:nvSpPr>
        <p:spPr>
          <a:xfrm>
            <a:off x="5221474" y="3377317"/>
            <a:ext cx="410369" cy="1846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Liver 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BE4CF3F0-7CCC-491B-944B-F2E7805A76F6}"/>
              </a:ext>
            </a:extLst>
          </p:cNvPr>
          <p:cNvCxnSpPr>
            <a:cxnSpLocks/>
            <a:stCxn id="19" idx="0"/>
          </p:cNvCxnSpPr>
          <p:nvPr/>
        </p:nvCxnSpPr>
        <p:spPr>
          <a:xfrm flipV="1">
            <a:off x="1321926" y="1862212"/>
            <a:ext cx="160303" cy="22378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矢印コネクタ 38">
            <a:extLst>
              <a:ext uri="{FF2B5EF4-FFF2-40B4-BE49-F238E27FC236}">
                <a16:creationId xmlns:a16="http://schemas.microsoft.com/office/drawing/2014/main" id="{4C82F4D3-D813-41A5-B31C-7F19BE5DB5B5}"/>
              </a:ext>
            </a:extLst>
          </p:cNvPr>
          <p:cNvCxnSpPr/>
          <p:nvPr/>
        </p:nvCxnSpPr>
        <p:spPr>
          <a:xfrm>
            <a:off x="1115616" y="3077579"/>
            <a:ext cx="0" cy="1746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矢印コネクタ 41">
            <a:extLst>
              <a:ext uri="{FF2B5EF4-FFF2-40B4-BE49-F238E27FC236}">
                <a16:creationId xmlns:a16="http://schemas.microsoft.com/office/drawing/2014/main" id="{F70189BF-DBB1-45E1-BECB-C0F18C443B96}"/>
              </a:ext>
            </a:extLst>
          </p:cNvPr>
          <p:cNvCxnSpPr>
            <a:cxnSpLocks/>
          </p:cNvCxnSpPr>
          <p:nvPr/>
        </p:nvCxnSpPr>
        <p:spPr>
          <a:xfrm>
            <a:off x="5476549" y="3561983"/>
            <a:ext cx="85866" cy="19105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E72DF829-4C62-4C89-ACD8-23ED22090630}"/>
              </a:ext>
            </a:extLst>
          </p:cNvPr>
          <p:cNvCxnSpPr>
            <a:cxnSpLocks/>
            <a:stCxn id="20" idx="2"/>
          </p:cNvCxnSpPr>
          <p:nvPr/>
        </p:nvCxnSpPr>
        <p:spPr>
          <a:xfrm flipH="1">
            <a:off x="3963347" y="2353644"/>
            <a:ext cx="59832" cy="17061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矢印コネクタ 47">
            <a:extLst>
              <a:ext uri="{FF2B5EF4-FFF2-40B4-BE49-F238E27FC236}">
                <a16:creationId xmlns:a16="http://schemas.microsoft.com/office/drawing/2014/main" id="{AAC04F26-BFFE-4A6F-B634-571EE3D8985E}"/>
              </a:ext>
            </a:extLst>
          </p:cNvPr>
          <p:cNvCxnSpPr/>
          <p:nvPr/>
        </p:nvCxnSpPr>
        <p:spPr>
          <a:xfrm flipV="1">
            <a:off x="2987824" y="3067767"/>
            <a:ext cx="0" cy="18448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矢印コネクタ 49">
            <a:extLst>
              <a:ext uri="{FF2B5EF4-FFF2-40B4-BE49-F238E27FC236}">
                <a16:creationId xmlns:a16="http://schemas.microsoft.com/office/drawing/2014/main" id="{A6FEF649-AE85-41EA-879E-2FB8B9DC84E3}"/>
              </a:ext>
            </a:extLst>
          </p:cNvPr>
          <p:cNvCxnSpPr/>
          <p:nvPr/>
        </p:nvCxnSpPr>
        <p:spPr>
          <a:xfrm flipV="1">
            <a:off x="3481820" y="4005652"/>
            <a:ext cx="0" cy="21137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矢印コネクタ 51">
            <a:extLst>
              <a:ext uri="{FF2B5EF4-FFF2-40B4-BE49-F238E27FC236}">
                <a16:creationId xmlns:a16="http://schemas.microsoft.com/office/drawing/2014/main" id="{8A4E91F8-88D1-48A0-ADE8-13ACB216B6D6}"/>
              </a:ext>
            </a:extLst>
          </p:cNvPr>
          <p:cNvCxnSpPr>
            <a:stCxn id="30" idx="0"/>
          </p:cNvCxnSpPr>
          <p:nvPr/>
        </p:nvCxnSpPr>
        <p:spPr>
          <a:xfrm flipV="1">
            <a:off x="6939955" y="3657509"/>
            <a:ext cx="115760" cy="9552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矢印コネクタ 53">
            <a:extLst>
              <a:ext uri="{FF2B5EF4-FFF2-40B4-BE49-F238E27FC236}">
                <a16:creationId xmlns:a16="http://schemas.microsoft.com/office/drawing/2014/main" id="{702CB9D6-0A97-48CD-B72B-B1C720CF1833}"/>
              </a:ext>
            </a:extLst>
          </p:cNvPr>
          <p:cNvCxnSpPr/>
          <p:nvPr/>
        </p:nvCxnSpPr>
        <p:spPr>
          <a:xfrm flipV="1">
            <a:off x="6291975" y="4217030"/>
            <a:ext cx="0" cy="18466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矢印コネクタ 55">
            <a:extLst>
              <a:ext uri="{FF2B5EF4-FFF2-40B4-BE49-F238E27FC236}">
                <a16:creationId xmlns:a16="http://schemas.microsoft.com/office/drawing/2014/main" id="{6586BDCC-3ADC-49BD-9A09-B529E6F7C175}"/>
              </a:ext>
            </a:extLst>
          </p:cNvPr>
          <p:cNvCxnSpPr>
            <a:stCxn id="28" idx="2"/>
          </p:cNvCxnSpPr>
          <p:nvPr/>
        </p:nvCxnSpPr>
        <p:spPr>
          <a:xfrm flipH="1">
            <a:off x="6625005" y="3436913"/>
            <a:ext cx="19980" cy="1234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91BBAE6C-F9FD-4041-9C98-10E07E60BAA3}"/>
              </a:ext>
            </a:extLst>
          </p:cNvPr>
          <p:cNvSpPr txBox="1"/>
          <p:nvPr/>
        </p:nvSpPr>
        <p:spPr>
          <a:xfrm>
            <a:off x="5188854" y="6366520"/>
            <a:ext cx="39478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“Vital Statistics”, Ministry of Health, </a:t>
            </a:r>
            <a:r>
              <a:rPr kumimoji="1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Labour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 and Welfare</a:t>
            </a: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(data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from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e-Stat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https://www.e-stat.go.jp/)</a:t>
            </a:r>
          </a:p>
        </p:txBody>
      </p:sp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id="{CCE036E5-EEFE-45D1-A992-3717C832C68F}"/>
              </a:ext>
            </a:extLst>
          </p:cNvPr>
          <p:cNvCxnSpPr/>
          <p:nvPr/>
        </p:nvCxnSpPr>
        <p:spPr>
          <a:xfrm>
            <a:off x="5925961" y="2132166"/>
            <a:ext cx="0" cy="2503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17479483"/>
      </p:ext>
    </p:extLst>
  </p:cSld>
  <p:clrMapOvr>
    <a:masterClrMapping/>
  </p:clrMapOvr>
</p:sld>
</file>

<file path=ppt/theme/theme1.xml><?xml version="1.0" encoding="utf-8"?>
<a:theme xmlns:a="http://schemas.openxmlformats.org/drawingml/2006/main" name="originalest_06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3">
      <a:majorFont>
        <a:latin typeface="Tahoma"/>
        <a:ea typeface="メイリオ"/>
        <a:cs typeface=""/>
      </a:majorFont>
      <a:minorFont>
        <a:latin typeface="Tahoma"/>
        <a:ea typeface="メイリオ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5_標準デザイン">
  <a:themeElements>
    <a:clrScheme name="標準デザイン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標準デザイン">
      <a:majorFont>
        <a:latin typeface="Times New Roman"/>
        <a:ea typeface="ＭＳ Ｐゴシック"/>
        <a:cs typeface=""/>
      </a:majorFont>
      <a:minorFont>
        <a:latin typeface="Times New Roman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08</TotalTime>
  <Words>59</Words>
  <Application>Microsoft Office PowerPoint</Application>
  <PresentationFormat>画面に合わせる (4:3)</PresentationFormat>
  <Paragraphs>1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ＭＳ Ｐゴシック</vt:lpstr>
      <vt:lpstr>ＭＳ Ｐ明朝</vt:lpstr>
      <vt:lpstr>メイリオ</vt:lpstr>
      <vt:lpstr>Arial</vt:lpstr>
      <vt:lpstr>Tahoma</vt:lpstr>
      <vt:lpstr>Times New Roman</vt:lpstr>
      <vt:lpstr>originalest_06</vt:lpstr>
      <vt:lpstr>5_標準デザイン</vt:lpstr>
      <vt:lpstr>Supplemental Figure 2 Annual trends in age-standardized mortality rate per 100,000 Japan 1985 model population for major cancer sites</vt:lpstr>
    </vt:vector>
  </TitlesOfParts>
  <Company>臨床疫学研究部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がん死亡者数の年次推移</dc:title>
  <dc:creator>kohashi</dc:creator>
  <cp:lastModifiedBy>Tsugane Shoi</cp:lastModifiedBy>
  <cp:revision>836</cp:revision>
  <cp:lastPrinted>2020-05-11T09:24:42Z</cp:lastPrinted>
  <dcterms:created xsi:type="dcterms:W3CDTF">2002-10-31T01:02:46Z</dcterms:created>
  <dcterms:modified xsi:type="dcterms:W3CDTF">2020-05-15T07:54:38Z</dcterms:modified>
</cp:coreProperties>
</file>